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4"/>
    <p:restoredTop sz="96543"/>
  </p:normalViewPr>
  <p:slideViewPr>
    <p:cSldViewPr snapToGrid="0" snapToObjects="1">
      <p:cViewPr varScale="1">
        <p:scale>
          <a:sx n="150" d="100"/>
          <a:sy n="150" d="100"/>
        </p:scale>
        <p:origin x="168" y="1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C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C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sumotoDaisuke/Desktop/Google%20Drive/01%20&#21338;&#22763;&#35542;&#25991;&#36039;&#26009;/01%20&#21338;&#22763;&#35542;&#25991;/01%20&#20027;&#35542;&#25991;(Development%20of%20computer%20based%20educational%20tools%20for%20childhood%20cancer%20survivors)/00%20&#35519;&#26619;&#32080;&#26524;/R2.2.9%20&#20877;&#20998;&#26512;&#65288;&#22528;&#20808;&#29983;&#12371;&#12441;&#25351;&#25688;&#20998;&#65289;/01%20Baseline&#12392;&#21508;&#35519;&#26619;&#26376;&#12398;&#38291;&#12398;&#20108;&#37089;&#27604;&#36611;/R2.2.9%20&#35519;&#26619;&#32080;&#26524;C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sumotoDaisuke/Google%20&#12488;&#12441;&#12521;&#12452;&#12501;&#12441;/01%20&#21338;&#22763;&#35542;&#25991;&#36039;&#26009;/01%20&#21338;&#22763;&#35542;&#25991;/01%20&#20027;&#35542;&#25991;(Development%20of%20computer%20based%20educational%20tools%20for%20childhood%20cancer%20survivors)/00%20&#35519;&#26619;&#32080;&#26524;/R4.2.2%20&#27161;&#28310;&#35492;&#24046;&#20462;&#27491;/01%20&#21508;&#35519;&#26619;&#26178;&#28857;&#12390;&#12441;&#21332;&#21147;&#12434;&#24471;&#12383;&#23550;&#35937;&#32773;&#12395;&#12362;&#12369;&#12427;2&#37089;&#27604;&#36611;(Baseline%20vs%201:6:12-month)/&#35519;&#26619;&#32080;&#26524;C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sumotoDaisuke/Google%20&#12488;&#12441;&#12521;&#12452;&#12501;&#12441;/01%20&#21338;&#22763;&#35542;&#25991;&#36039;&#26009;/01%20&#21338;&#22763;&#35542;&#25991;/01%20&#20027;&#35542;&#25991;(Development%20of%20computer%20based%20educational%20tools%20for%20childhood%20cancer%20survivors)/00%20&#35519;&#26619;&#32080;&#26524;/R4.2.2%20&#27161;&#28310;&#35492;&#24046;&#20462;&#27491;/01%20&#21508;&#35519;&#26619;&#26178;&#28857;&#12390;&#12441;&#21332;&#21147;&#12434;&#24471;&#12383;&#23550;&#35937;&#32773;&#12395;&#12362;&#12369;&#12427;2&#37089;&#27604;&#36611;(Baseline%20vs%201:6:12-month)/&#35519;&#26619;&#32080;&#26524;B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sumotoDaisuke/Google%20&#12488;&#12441;&#12521;&#12452;&#12501;&#12441;/01%20&#21338;&#22763;&#35542;&#25991;&#36039;&#26009;/01%20&#21338;&#22763;&#35542;&#25991;/01%20&#20027;&#35542;&#25991;(Development%20of%20computer%20based%20educational%20tools%20for%20childhood%20cancer%20survivors)/00%20&#35519;&#26619;&#32080;&#26524;/R4.2.2%20&#27161;&#28310;&#35492;&#24046;&#20462;&#27491;/01%20&#21508;&#35519;&#26619;&#26178;&#28857;&#12390;&#12441;&#21332;&#21147;&#12434;&#24471;&#12383;&#23550;&#35937;&#32773;&#12395;&#12362;&#12369;&#12427;2&#37089;&#27604;&#36611;(Baseline%20vs%201:6:12-month)/&#35519;&#26619;&#32080;&#26524;B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sumotoDaisuke/Google%20&#12488;&#12441;&#12521;&#12452;&#12501;&#12441;/01%20&#21338;&#22763;&#35542;&#25991;&#36039;&#26009;/01%20&#21338;&#22763;&#35542;&#25991;/01%20&#20027;&#35542;&#25991;(Development%20of%20computer%20based%20educational%20tools%20for%20childhood%20cancer%20survivors)/00%20&#35519;&#26619;&#32080;&#26524;/R4.2.2%20&#27161;&#28310;&#35492;&#24046;&#20462;&#27491;/01%20&#21508;&#35519;&#26619;&#26178;&#28857;&#12390;&#12441;&#21332;&#21147;&#12434;&#24471;&#12383;&#23550;&#35937;&#32773;&#12395;&#12362;&#12369;&#12427;2&#37089;&#27604;&#36611;(Baseline%20vs%201:6:12-month)/&#35519;&#26619;&#32080;&#26524;B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sumotoDaisuke/Google%20&#12488;&#12441;&#12521;&#12452;&#12501;&#12441;/01%20&#21338;&#22763;&#35542;&#25991;&#36039;&#26009;/01%20&#21338;&#22763;&#35542;&#25991;/01%20&#20027;&#35542;&#25991;(Development%20of%20computer%20based%20educational%20tools%20for%20childhood%20cancer%20survivors)/00%20&#35519;&#26619;&#32080;&#26524;/R4.2.2%20&#27161;&#28310;&#35492;&#24046;&#20462;&#27491;/01%20&#21508;&#35519;&#26619;&#26178;&#28857;&#12390;&#12441;&#21332;&#21147;&#12434;&#24471;&#12383;&#23550;&#35937;&#32773;&#12395;&#12362;&#12369;&#12427;2&#37089;&#27604;&#36611;(Baseline%20vs%201:6:12-month)/&#35519;&#26619;&#32080;&#26524;C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sumotoDaisuke/Google%20&#12488;&#12441;&#12521;&#12452;&#12501;&#12441;/01%20&#21338;&#22763;&#35542;&#25991;&#36039;&#26009;/01%20&#21338;&#22763;&#35542;&#25991;/01%20&#20027;&#35542;&#25991;(Development%20of%20computer%20based%20educational%20tools%20for%20childhood%20cancer%20survivors)/00%20&#35519;&#26619;&#32080;&#26524;/R4.2.2%20&#27161;&#28310;&#35492;&#24046;&#20462;&#27491;/01%20&#21508;&#35519;&#26619;&#26178;&#28857;&#12390;&#12441;&#21332;&#21147;&#12434;&#24471;&#12383;&#23550;&#35937;&#32773;&#12395;&#12362;&#12369;&#12427;2&#37089;&#27604;&#36611;(Baseline%20vs%201:6:12-month)/&#35519;&#26619;&#32080;&#26524;C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C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C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C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asumotoDaisuke\Desktop\Google%20Drive\01%20&#21338;&#22763;&#35542;&#25991;&#36039;&#26009;\01%20&#21338;&#22763;&#35542;&#25991;\01%20&#20027;&#35542;&#25991;(Development%20of%20computer%20based%20educational%20tools%20for%20childhood%20cancer%20survivors)\00%20&#35519;&#26619;&#32080;&#26524;\R2.2.9%20&#20877;&#20998;&#26512;&#65288;&#22528;&#20808;&#29983;&#12371;&#12441;&#25351;&#25688;&#20998;&#65289;\R2.2.9%20&#35519;&#26619;&#32080;&#26524;B(&#23567;&#20013;&#23398;&#29983;)&#26368;&#32066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868699424748048"/>
          <c:y val="5.1089483732965707E-2"/>
          <c:w val="0.78908796296296291"/>
          <c:h val="0.90298611111111116"/>
        </c:manualLayout>
      </c:layout>
      <c:barChart>
        <c:barDir val="col"/>
        <c:grouping val="stacked"/>
        <c:varyColors val="0"/>
        <c:ser>
          <c:idx val="2"/>
          <c:order val="0"/>
          <c:tx>
            <c:strRef>
              <c:f>'Ｂ郡(BL-1M)'!$EG$64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1M)'!$EH$65:$EI$65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0.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Ｂ郡(BL-1M)'!$EH$1,'Ｂ郡(BL-1M)'!$EI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H$64,'Ｂ郡(BL-1M)'!$EI$64)</c:f>
              <c:numCache>
                <c:formatCode>0</c:formatCode>
                <c:ptCount val="2"/>
                <c:pt idx="0">
                  <c:v>19</c:v>
                </c:pt>
                <c:pt idx="1">
                  <c:v>24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53-554C-ADD2-21C973AFEE33}"/>
            </c:ext>
          </c:extLst>
        </c:ser>
        <c:ser>
          <c:idx val="1"/>
          <c:order val="1"/>
          <c:tx>
            <c:strRef>
              <c:f>'Ｂ郡(BL-1M)'!$EG$63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('Ｂ郡(BL-1M)'!$EH$1,'Ｂ郡(BL-1M)'!$EI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H$63,'Ｂ郡(BL-1M)'!$EI$63)</c:f>
              <c:numCache>
                <c:formatCode>0</c:formatCode>
                <c:ptCount val="2"/>
                <c:pt idx="0">
                  <c:v>1</c:v>
                </c:pt>
                <c:pt idx="1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53-554C-ADD2-21C973AFEE33}"/>
            </c:ext>
          </c:extLst>
        </c:ser>
        <c:ser>
          <c:idx val="0"/>
          <c:order val="2"/>
          <c:tx>
            <c:strRef>
              <c:f>'Ｂ郡(BL-1M)'!$EG$62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1M)'!$EH$61:$EI$61</c:f>
                <c:numCache>
                  <c:formatCode>General</c:formatCode>
                  <c:ptCount val="2"/>
                  <c:pt idx="0">
                    <c:v>3.5</c:v>
                  </c:pt>
                  <c:pt idx="1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Ｂ郡(BL-1M)'!$EH$1,'Ｂ郡(BL-1M)'!$EI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H$62,'Ｂ郡(BL-1M)'!$EI$62)</c:f>
              <c:numCache>
                <c:formatCode>0</c:formatCode>
                <c:ptCount val="2"/>
                <c:pt idx="0">
                  <c:v>0.5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B53-554C-ADD2-21C973AFEE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88072448"/>
        <c:axId val="288073624"/>
      </c:barChart>
      <c:catAx>
        <c:axId val="2880724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88073624"/>
        <c:crosses val="autoZero"/>
        <c:auto val="1"/>
        <c:lblAlgn val="ctr"/>
        <c:lblOffset val="100"/>
        <c:noMultiLvlLbl val="0"/>
      </c:catAx>
      <c:valAx>
        <c:axId val="288073624"/>
        <c:scaling>
          <c:orientation val="minMax"/>
          <c:max val="3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8807244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1M)'!$EK$58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1M)'!$EL$59:$EM$59</c:f>
                <c:numCache>
                  <c:formatCode>General</c:formatCode>
                  <c:ptCount val="2"/>
                  <c:pt idx="0">
                    <c:v>4</c:v>
                  </c:pt>
                  <c:pt idx="1">
                    <c:v>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Ｂ郡(BL-1M)'!$EL$1,'Ｂ郡(BL-1M)'!$EM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L$58,'Ｂ郡(BL-1M)'!$EM$58)</c:f>
              <c:numCache>
                <c:formatCode>0</c:formatCode>
                <c:ptCount val="2"/>
                <c:pt idx="0">
                  <c:v>26</c:v>
                </c:pt>
                <c:pt idx="1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35-1147-8A5E-B13821104732}"/>
            </c:ext>
          </c:extLst>
        </c:ser>
        <c:ser>
          <c:idx val="1"/>
          <c:order val="1"/>
          <c:tx>
            <c:strRef>
              <c:f>'Ｂ郡(BL-1M)'!$EK$57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('Ｂ郡(BL-1M)'!$EL$1,'Ｂ郡(BL-1M)'!$EM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L$57,'Ｂ郡(BL-1M)'!$EM$57)</c:f>
              <c:numCache>
                <c:formatCode>0</c:formatCode>
                <c:ptCount val="2"/>
                <c:pt idx="0">
                  <c:v>3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C35-1147-8A5E-B13821104732}"/>
            </c:ext>
          </c:extLst>
        </c:ser>
        <c:ser>
          <c:idx val="0"/>
          <c:order val="2"/>
          <c:tx>
            <c:strRef>
              <c:f>'Ｂ郡(BL-1M)'!$EK$56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1M)'!$EL$55:$EM$55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Ｂ郡(BL-1M)'!$EL$1,'Ｂ郡(BL-1M)'!$EM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L$56,'Ｂ郡(BL-1M)'!$EM$56)</c:f>
              <c:numCache>
                <c:formatCode>0</c:formatCode>
                <c:ptCount val="2"/>
                <c:pt idx="0">
                  <c:v>2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C35-1147-8A5E-B138211047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312628848"/>
        <c:axId val="312629240"/>
      </c:barChart>
      <c:catAx>
        <c:axId val="3126288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2629240"/>
        <c:crosses val="autoZero"/>
        <c:auto val="1"/>
        <c:lblAlgn val="ctr"/>
        <c:lblOffset val="100"/>
        <c:noMultiLvlLbl val="0"/>
      </c:catAx>
      <c:valAx>
        <c:axId val="312629240"/>
        <c:scaling>
          <c:orientation val="minMax"/>
          <c:max val="5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31262884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C郡（BL-1M)'!$FJ$71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C郡（BL-1M)'!$FK$72:$FN$72</c:f>
                <c:numCache>
                  <c:formatCode>General</c:formatCode>
                  <c:ptCount val="4"/>
                  <c:pt idx="0">
                    <c:v>8</c:v>
                  </c:pt>
                  <c:pt idx="1">
                    <c:v>13.5</c:v>
                  </c:pt>
                  <c:pt idx="2">
                    <c:v>12</c:v>
                  </c:pt>
                  <c:pt idx="3">
                    <c:v>1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M)'!$FK$2,'C郡（BL-1M)'!$FL$2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C郡（BL-1M)'!$FK$71,'C郡（BL-1M)'!$FL$71)</c:f>
              <c:numCache>
                <c:formatCode>0.00_);[Red]\(0.00\)</c:formatCode>
                <c:ptCount val="2"/>
                <c:pt idx="0">
                  <c:v>32</c:v>
                </c:pt>
                <c:pt idx="1">
                  <c:v>3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E3-AC48-A39A-7385BCA1CB3B}"/>
            </c:ext>
          </c:extLst>
        </c:ser>
        <c:ser>
          <c:idx val="1"/>
          <c:order val="1"/>
          <c:tx>
            <c:strRef>
              <c:f>'C郡（BL-1M)'!$FJ$70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('C郡（BL-1M)'!$FK$2,'C郡（BL-1M)'!$FL$2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C郡（BL-1M)'!$FK$70,'C郡（BL-1M)'!$FL$70)</c:f>
              <c:numCache>
                <c:formatCode>0.00_);[Red]\(0.00\)</c:formatCode>
                <c:ptCount val="2"/>
                <c:pt idx="0">
                  <c:v>1.5</c:v>
                </c:pt>
                <c:pt idx="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E3-AC48-A39A-7385BCA1CB3B}"/>
            </c:ext>
          </c:extLst>
        </c:ser>
        <c:ser>
          <c:idx val="0"/>
          <c:order val="2"/>
          <c:tx>
            <c:strRef>
              <c:f>'C郡（BL-1M)'!$FJ$69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郡（BL-1M)'!$FK$68:$FN$68</c:f>
                <c:numCache>
                  <c:formatCode>General</c:formatCode>
                  <c:ptCount val="4"/>
                  <c:pt idx="0">
                    <c:v>8.25</c:v>
                  </c:pt>
                  <c:pt idx="1">
                    <c:v>7</c:v>
                  </c:pt>
                  <c:pt idx="2">
                    <c:v>7.75</c:v>
                  </c:pt>
                  <c:pt idx="3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M)'!$FK$2,'C郡（BL-1M)'!$FL$2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C郡（BL-1M)'!$FK$69,'C郡（BL-1M)'!$FL$69)</c:f>
              <c:numCache>
                <c:formatCode>0.00_);[Red]\(0.00\)</c:formatCode>
                <c:ptCount val="2"/>
                <c:pt idx="0">
                  <c:v>4.25</c:v>
                </c:pt>
                <c:pt idx="1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7E3-AC48-A39A-7385BCA1CB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312630024"/>
        <c:axId val="312630416"/>
      </c:barChart>
      <c:catAx>
        <c:axId val="3126300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2630416"/>
        <c:crosses val="autoZero"/>
        <c:auto val="1"/>
        <c:lblAlgn val="ctr"/>
        <c:lblOffset val="100"/>
        <c:noMultiLvlLbl val="0"/>
      </c:catAx>
      <c:valAx>
        <c:axId val="312630416"/>
        <c:scaling>
          <c:orientation val="minMax"/>
          <c:max val="5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31263002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C郡（BL-6M) '!$FJ$67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C郡（BL-6M) '!$FK$68:$FN$68</c:f>
                <c:numCache>
                  <c:formatCode>General</c:formatCode>
                  <c:ptCount val="4"/>
                  <c:pt idx="0">
                    <c:v>8</c:v>
                  </c:pt>
                  <c:pt idx="1">
                    <c:v>13</c:v>
                  </c:pt>
                  <c:pt idx="2">
                    <c:v>12</c:v>
                  </c:pt>
                  <c:pt idx="3">
                    <c:v>12.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6M) '!$FK$2,'C郡（BL-6M) '!$FM$2)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('C郡（BL-6M) '!$FK$67,'C郡（BL-6M) '!$FM$67)</c:f>
              <c:numCache>
                <c:formatCode>0.00_);[Red]\(0.00\)</c:formatCode>
                <c:ptCount val="2"/>
                <c:pt idx="0">
                  <c:v>32</c:v>
                </c:pt>
                <c:pt idx="1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35-CF49-ACB7-6391BB189619}"/>
            </c:ext>
          </c:extLst>
        </c:ser>
        <c:ser>
          <c:idx val="1"/>
          <c:order val="1"/>
          <c:tx>
            <c:strRef>
              <c:f>'C郡（BL-6M) '!$FJ$66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('C郡（BL-6M) '!$FK$2,'C郡（BL-6M) '!$FM$2)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('C郡（BL-6M) '!$FK$66,'C郡（BL-6M) '!$FM$66)</c:f>
              <c:numCache>
                <c:formatCode>0.00_);[Red]\(0.00\)</c:formatCode>
                <c:ptCount val="2"/>
                <c:pt idx="0">
                  <c:v>2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A35-CF49-ACB7-6391BB189619}"/>
            </c:ext>
          </c:extLst>
        </c:ser>
        <c:ser>
          <c:idx val="0"/>
          <c:order val="2"/>
          <c:tx>
            <c:strRef>
              <c:f>'C郡（BL-6M) '!$FJ$65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郡（BL-6M) '!$FK$64:$FN$64</c:f>
                <c:numCache>
                  <c:formatCode>General</c:formatCode>
                  <c:ptCount val="4"/>
                  <c:pt idx="0">
                    <c:v>8.25</c:v>
                  </c:pt>
                  <c:pt idx="1">
                    <c:v>7</c:v>
                  </c:pt>
                  <c:pt idx="2">
                    <c:v>7.25</c:v>
                  </c:pt>
                  <c:pt idx="3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6M) '!$FK$2,'C郡（BL-6M) '!$FM$2)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('C郡（BL-6M) '!$FK$65,'C郡（BL-6M) '!$FM$65)</c:f>
              <c:numCache>
                <c:formatCode>0.00_);[Red]\(0.00\)</c:formatCode>
                <c:ptCount val="2"/>
                <c:pt idx="0">
                  <c:v>3.75</c:v>
                </c:pt>
                <c:pt idx="1">
                  <c:v>4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A35-CF49-ACB7-6391BB1896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312631592"/>
        <c:axId val="312631984"/>
      </c:barChart>
      <c:catAx>
        <c:axId val="3126315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2631984"/>
        <c:crosses val="autoZero"/>
        <c:auto val="1"/>
        <c:lblAlgn val="ctr"/>
        <c:lblOffset val="100"/>
        <c:noMultiLvlLbl val="0"/>
      </c:catAx>
      <c:valAx>
        <c:axId val="312631984"/>
        <c:scaling>
          <c:orientation val="minMax"/>
          <c:max val="5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31263159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６M) '!$EK$55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６M) '!$EL$56:$EM$56</c:f>
                <c:numCache>
                  <c:formatCode>General</c:formatCode>
                  <c:ptCount val="2"/>
                  <c:pt idx="0">
                    <c:v>4.5</c:v>
                  </c:pt>
                  <c:pt idx="1">
                    <c:v>8.2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６M) '!$EL$1:$EM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L$55:$EM$55</c:f>
              <c:numCache>
                <c:formatCode>0.00</c:formatCode>
                <c:ptCount val="2"/>
                <c:pt idx="0">
                  <c:v>26.5</c:v>
                </c:pt>
                <c:pt idx="1">
                  <c:v>29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B5-8B47-B490-8D9A9B9189D5}"/>
            </c:ext>
          </c:extLst>
        </c:ser>
        <c:ser>
          <c:idx val="1"/>
          <c:order val="1"/>
          <c:tx>
            <c:strRef>
              <c:f>'Ｂ郡(BL-６M) '!$EK$54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Ｂ郡(BL-６M) '!$EL$1:$EM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L$54:$EM$54</c:f>
              <c:numCache>
                <c:formatCode>0.00</c:formatCode>
                <c:ptCount val="2"/>
                <c:pt idx="0">
                  <c:v>2.5</c:v>
                </c:pt>
                <c:pt idx="1">
                  <c:v>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EB5-8B47-B490-8D9A9B9189D5}"/>
            </c:ext>
          </c:extLst>
        </c:ser>
        <c:ser>
          <c:idx val="0"/>
          <c:order val="2"/>
          <c:tx>
            <c:strRef>
              <c:f>'Ｂ郡(BL-６M) '!$EK$53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６M) '!$EL$52:$EM$52</c:f>
                <c:numCache>
                  <c:formatCode>General</c:formatCode>
                  <c:ptCount val="2"/>
                  <c:pt idx="0">
                    <c:v>6.25</c:v>
                  </c:pt>
                  <c:pt idx="1">
                    <c:v>3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６M) '!$EL$1:$EM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L$53:$EM$53</c:f>
              <c:numCache>
                <c:formatCode>0.00</c:formatCode>
                <c:ptCount val="2"/>
                <c:pt idx="0">
                  <c:v>1.75</c:v>
                </c:pt>
                <c:pt idx="1">
                  <c:v>4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EB5-8B47-B490-8D9A9B9189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312864216"/>
        <c:axId val="312864608"/>
      </c:barChart>
      <c:catAx>
        <c:axId val="3128642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2864608"/>
        <c:crosses val="autoZero"/>
        <c:auto val="1"/>
        <c:lblAlgn val="ctr"/>
        <c:lblOffset val="100"/>
        <c:noMultiLvlLbl val="0"/>
      </c:catAx>
      <c:valAx>
        <c:axId val="312864608"/>
        <c:scaling>
          <c:orientation val="minMax"/>
          <c:max val="5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312864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12M) '!$EK$55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12M) '!$EL$56:$EM$56</c:f>
                <c:numCache>
                  <c:formatCode>General</c:formatCode>
                  <c:ptCount val="2"/>
                  <c:pt idx="0">
                    <c:v>4.5</c:v>
                  </c:pt>
                  <c:pt idx="1">
                    <c:v>8.2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2M) '!$EL$1:$EM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L$55:$EM$55</c:f>
              <c:numCache>
                <c:formatCode>0.00</c:formatCode>
                <c:ptCount val="2"/>
                <c:pt idx="0">
                  <c:v>26.5</c:v>
                </c:pt>
                <c:pt idx="1">
                  <c:v>29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02-1549-8BCF-E0B46894C7D3}"/>
            </c:ext>
          </c:extLst>
        </c:ser>
        <c:ser>
          <c:idx val="1"/>
          <c:order val="1"/>
          <c:tx>
            <c:strRef>
              <c:f>'Ｂ郡(BL-12M) '!$EK$54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Ｂ郡(BL-12M) '!$EL$1:$EM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L$54:$EM$54</c:f>
              <c:numCache>
                <c:formatCode>0.00</c:formatCode>
                <c:ptCount val="2"/>
                <c:pt idx="0">
                  <c:v>2.5</c:v>
                </c:pt>
                <c:pt idx="1">
                  <c:v>2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802-1549-8BCF-E0B46894C7D3}"/>
            </c:ext>
          </c:extLst>
        </c:ser>
        <c:ser>
          <c:idx val="0"/>
          <c:order val="2"/>
          <c:tx>
            <c:strRef>
              <c:f>'Ｂ郡(BL-12M) '!$EK$53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12M) '!$EL$52:$EM$52</c:f>
                <c:numCache>
                  <c:formatCode>General</c:formatCode>
                  <c:ptCount val="2"/>
                  <c:pt idx="0">
                    <c:v>6.25</c:v>
                  </c:pt>
                  <c:pt idx="1">
                    <c:v>4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2M) '!$EL$1:$EM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L$53:$EM$53</c:f>
              <c:numCache>
                <c:formatCode>0.00</c:formatCode>
                <c:ptCount val="2"/>
                <c:pt idx="0">
                  <c:v>1.75</c:v>
                </c:pt>
                <c:pt idx="1">
                  <c:v>1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802-1549-8BCF-E0B46894C7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312865392"/>
        <c:axId val="312865784"/>
      </c:barChart>
      <c:catAx>
        <c:axId val="3128653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2865784"/>
        <c:crosses val="autoZero"/>
        <c:auto val="1"/>
        <c:lblAlgn val="ctr"/>
        <c:lblOffset val="100"/>
        <c:noMultiLvlLbl val="0"/>
      </c:catAx>
      <c:valAx>
        <c:axId val="312865784"/>
        <c:scaling>
          <c:orientation val="minMax"/>
          <c:max val="5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31286539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C郡（BL-12M)'!$FJ$60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C郡（BL-12M)'!$FK$61:$FN$61</c:f>
                <c:numCache>
                  <c:formatCode>General</c:formatCode>
                  <c:ptCount val="4"/>
                  <c:pt idx="0">
                    <c:v>8</c:v>
                  </c:pt>
                  <c:pt idx="1">
                    <c:v>13</c:v>
                  </c:pt>
                  <c:pt idx="2">
                    <c:v>12</c:v>
                  </c:pt>
                  <c:pt idx="3">
                    <c:v>12.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2M)'!$FK$2,'C郡（BL-12M)'!$FN$2)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('C郡（BL-12M)'!$FK$60,'C郡（BL-12M)'!$FN$60)</c:f>
              <c:numCache>
                <c:formatCode>0.00_);[Red]\(0.00\)</c:formatCode>
                <c:ptCount val="2"/>
                <c:pt idx="0">
                  <c:v>32</c:v>
                </c:pt>
                <c:pt idx="1">
                  <c:v>3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F1-E848-80C3-7D33C5806073}"/>
            </c:ext>
          </c:extLst>
        </c:ser>
        <c:ser>
          <c:idx val="1"/>
          <c:order val="1"/>
          <c:tx>
            <c:strRef>
              <c:f>'C郡（BL-12M)'!$FJ$59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('C郡（BL-12M)'!$FK$2,'C郡（BL-12M)'!$FN$2)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('C郡（BL-12M)'!$FK$59,'C郡（BL-12M)'!$FN$59)</c:f>
              <c:numCache>
                <c:formatCode>0.00_);[Red]\(0.00\)</c:formatCode>
                <c:ptCount val="2"/>
                <c:pt idx="0">
                  <c:v>2</c:v>
                </c:pt>
                <c:pt idx="1">
                  <c:v>1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F1-E848-80C3-7D33C5806073}"/>
            </c:ext>
          </c:extLst>
        </c:ser>
        <c:ser>
          <c:idx val="0"/>
          <c:order val="2"/>
          <c:tx>
            <c:strRef>
              <c:f>'C郡（BL-12M)'!$FJ$58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C郡（BL-12M)'!$FK$57,'C郡（BL-12M)'!$FN$57)</c:f>
                <c:numCache>
                  <c:formatCode>General</c:formatCode>
                  <c:ptCount val="2"/>
                  <c:pt idx="0">
                    <c:v>7</c:v>
                  </c:pt>
                  <c:pt idx="1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2M)'!$FK$2,'C郡（BL-12M)'!$FN$2)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('C郡（BL-12M)'!$FK$58,'C郡（BL-12M)'!$FN$58)</c:f>
              <c:numCache>
                <c:formatCode>0.00_);[Red]\(0.00\)</c:formatCode>
                <c:ptCount val="2"/>
                <c:pt idx="0">
                  <c:v>5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FF1-E848-80C3-7D33C58060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349853016"/>
        <c:axId val="349853408"/>
      </c:barChart>
      <c:catAx>
        <c:axId val="3498530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49853408"/>
        <c:crosses val="autoZero"/>
        <c:auto val="1"/>
        <c:lblAlgn val="ctr"/>
        <c:lblOffset val="100"/>
        <c:noMultiLvlLbl val="0"/>
      </c:catAx>
      <c:valAx>
        <c:axId val="349853408"/>
        <c:scaling>
          <c:orientation val="minMax"/>
          <c:max val="5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34985301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5400" cap="rnd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6"/>
              <c:spPr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FFA7-6A47-A14A-F39AB2C5232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C郡（BL-6M) '!$FM$43:$FN$43</c:f>
                <c:numCache>
                  <c:formatCode>General</c:formatCode>
                  <c:ptCount val="2"/>
                  <c:pt idx="0">
                    <c:v>0.37326624994005797</c:v>
                  </c:pt>
                  <c:pt idx="1">
                    <c:v>0.26514188110259301</c:v>
                  </c:pt>
                </c:numCache>
              </c:numRef>
            </c:plus>
            <c:minus>
              <c:numRef>
                <c:f>'C郡（BL-1M)'!$FM$47:$FN$47</c:f>
                <c:numCache>
                  <c:formatCode>General</c:formatCode>
                  <c:ptCount val="2"/>
                  <c:pt idx="0">
                    <c:v>0.35619308476315964</c:v>
                  </c:pt>
                  <c:pt idx="1">
                    <c:v>0.2408665659986987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C郡（BL-6M) '!$FM$2,'C郡（BL-6M) '!$FN$2)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('C郡（BL-6M) '!$FM$42,'C郡（BL-6M) '!$FN$42)</c:f>
              <c:numCache>
                <c:formatCode>0.00_);[Red]\(0.00\)</c:formatCode>
                <c:ptCount val="2"/>
                <c:pt idx="0">
                  <c:v>6.9473684210526319</c:v>
                </c:pt>
                <c:pt idx="1">
                  <c:v>9.36842105263157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FA7-6A47-A14A-F39AB2C523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1192800"/>
        <c:axId val="452789984"/>
      </c:lineChart>
      <c:catAx>
        <c:axId val="45119280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52789984"/>
        <c:crosses val="autoZero"/>
        <c:auto val="1"/>
        <c:lblAlgn val="ctr"/>
        <c:lblOffset val="100"/>
        <c:noMultiLvlLbl val="0"/>
      </c:catAx>
      <c:valAx>
        <c:axId val="452789984"/>
        <c:scaling>
          <c:orientation val="minMax"/>
          <c:max val="12"/>
          <c:min val="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5119280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>
                  <a:lumMod val="75000"/>
                  <a:lumOff val="25000"/>
                </a:schemeClr>
              </a:solidFill>
              <a:ln w="9525"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Ｂ郡(BL-1M)'!$EP$31:$EQ$31</c:f>
                <c:numCache>
                  <c:formatCode>General</c:formatCode>
                  <c:ptCount val="2"/>
                  <c:pt idx="0">
                    <c:v>0.23522074352816133</c:v>
                  </c:pt>
                  <c:pt idx="1">
                    <c:v>0.26979458046124366</c:v>
                  </c:pt>
                </c:numCache>
              </c:numRef>
            </c:plus>
            <c:minus>
              <c:numRef>
                <c:f>'Ｂ郡(BL-1M)'!$EP$31:$EQ$31</c:f>
                <c:numCache>
                  <c:formatCode>General</c:formatCode>
                  <c:ptCount val="2"/>
                  <c:pt idx="0">
                    <c:v>0.23522074352816133</c:v>
                  </c:pt>
                  <c:pt idx="1">
                    <c:v>0.2697945804612436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M)'!$EP$1:$EQ$1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'Ｂ郡(BL-1M)'!$EP$30:$EQ$30</c:f>
              <c:numCache>
                <c:formatCode>0.00</c:formatCode>
                <c:ptCount val="2"/>
                <c:pt idx="0">
                  <c:v>2.1904761904761907</c:v>
                </c:pt>
                <c:pt idx="1">
                  <c:v>4.85714285714285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6E1-E240-A18E-5AE56E0850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72603552"/>
        <c:axId val="272674216"/>
      </c:lineChart>
      <c:catAx>
        <c:axId val="2726035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72674216"/>
        <c:crosses val="autoZero"/>
        <c:auto val="1"/>
        <c:lblAlgn val="ctr"/>
        <c:lblOffset val="100"/>
        <c:noMultiLvlLbl val="0"/>
      </c:catAx>
      <c:valAx>
        <c:axId val="272674216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7260355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>
                  <a:lumMod val="75000"/>
                  <a:lumOff val="25000"/>
                </a:schemeClr>
              </a:solidFill>
              <a:ln w="9525"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Ｂ郡(BL-1M)'!$EP$31:$EQ$31</c:f>
                <c:numCache>
                  <c:formatCode>General</c:formatCode>
                  <c:ptCount val="2"/>
                  <c:pt idx="0">
                    <c:v>0.23522074352816133</c:v>
                  </c:pt>
                  <c:pt idx="1">
                    <c:v>0.26979458046124366</c:v>
                  </c:pt>
                </c:numCache>
              </c:numRef>
            </c:plus>
            <c:minus>
              <c:numRef>
                <c:f>'Ｂ郡(BL-1M)'!$EP$31:$EQ$31</c:f>
                <c:numCache>
                  <c:formatCode>General</c:formatCode>
                  <c:ptCount val="2"/>
                  <c:pt idx="0">
                    <c:v>0.23522074352816133</c:v>
                  </c:pt>
                  <c:pt idx="1">
                    <c:v>0.2697945804612436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M)'!$EP$1:$EQ$1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'Ｂ郡(BL-1M)'!$EP$30:$EQ$30</c:f>
              <c:numCache>
                <c:formatCode>0.00</c:formatCode>
                <c:ptCount val="2"/>
                <c:pt idx="0">
                  <c:v>2.1904761904761907</c:v>
                </c:pt>
                <c:pt idx="1">
                  <c:v>4.85714285714285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5B1-A041-8B28-2E0CBF7D90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72603552"/>
        <c:axId val="272674216"/>
      </c:lineChart>
      <c:catAx>
        <c:axId val="2726035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72674216"/>
        <c:crosses val="autoZero"/>
        <c:auto val="1"/>
        <c:lblAlgn val="ctr"/>
        <c:lblOffset val="100"/>
        <c:noMultiLvlLbl val="0"/>
      </c:catAx>
      <c:valAx>
        <c:axId val="272674216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7260355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>
                  <a:lumMod val="75000"/>
                  <a:lumOff val="25000"/>
                </a:schemeClr>
              </a:solidFill>
              <a:ln w="9525"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Ｂ郡(BL-12M) '!$EP$28:$EQ$28</c:f>
                <c:numCache>
                  <c:formatCode>General</c:formatCode>
                  <c:ptCount val="2"/>
                  <c:pt idx="0">
                    <c:v>0.2306411763214887</c:v>
                  </c:pt>
                  <c:pt idx="1">
                    <c:v>0.33793125168323451</c:v>
                  </c:pt>
                </c:numCache>
              </c:numRef>
            </c:plus>
            <c:minus>
              <c:numRef>
                <c:f>'Ｂ郡(BL-12M) '!$EP$28:$EQ$28</c:f>
                <c:numCache>
                  <c:formatCode>General</c:formatCode>
                  <c:ptCount val="2"/>
                  <c:pt idx="0">
                    <c:v>0.2306411763214887</c:v>
                  </c:pt>
                  <c:pt idx="1">
                    <c:v>0.3379312516832345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2M) '!$EP$1:$EQ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P$27:$EQ$27</c:f>
              <c:numCache>
                <c:formatCode>0.00</c:formatCode>
                <c:ptCount val="2"/>
                <c:pt idx="0">
                  <c:v>2.3888888888888888</c:v>
                </c:pt>
                <c:pt idx="1">
                  <c:v>4.05555555555555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B55-3E41-9CA1-1FF816185B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74109336"/>
        <c:axId val="274109728"/>
      </c:lineChart>
      <c:catAx>
        <c:axId val="27410933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74109728"/>
        <c:crosses val="autoZero"/>
        <c:auto val="1"/>
        <c:lblAlgn val="ctr"/>
        <c:lblOffset val="100"/>
        <c:noMultiLvlLbl val="0"/>
      </c:catAx>
      <c:valAx>
        <c:axId val="274109728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74109336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1M)'!$EG$49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1M)'!$EH$50:$EI$50</c:f>
                <c:numCache>
                  <c:formatCode>General</c:formatCode>
                  <c:ptCount val="2"/>
                  <c:pt idx="0">
                    <c:v>1.25</c:v>
                  </c:pt>
                  <c:pt idx="1">
                    <c:v>1.2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Ｂ郡(BL-1M)'!$EH$1,'Ｂ郡(BL-1M)'!$EI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H$49,'Ｂ郡(BL-1M)'!$EI$49)</c:f>
              <c:numCache>
                <c:formatCode>0</c:formatCode>
                <c:ptCount val="2"/>
                <c:pt idx="0">
                  <c:v>20.25</c:v>
                </c:pt>
                <c:pt idx="1">
                  <c:v>29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37-D04F-BED9-BAC5E5ADD93E}"/>
            </c:ext>
          </c:extLst>
        </c:ser>
        <c:ser>
          <c:idx val="1"/>
          <c:order val="1"/>
          <c:tx>
            <c:strRef>
              <c:f>'Ｂ郡(BL-1M)'!$EG$48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('Ｂ郡(BL-1M)'!$EH$1,'Ｂ郡(BL-1M)'!$EI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H$48,'Ｂ郡(BL-1M)'!$EI$48)</c:f>
              <c:numCache>
                <c:formatCode>0</c:formatCode>
                <c:ptCount val="2"/>
                <c:pt idx="0">
                  <c:v>1.25</c:v>
                </c:pt>
                <c:pt idx="1">
                  <c:v>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037-D04F-BED9-BAC5E5ADD93E}"/>
            </c:ext>
          </c:extLst>
        </c:ser>
        <c:ser>
          <c:idx val="0"/>
          <c:order val="2"/>
          <c:tx>
            <c:strRef>
              <c:f>'Ｂ郡(BL-1M)'!$EG$47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1M)'!$EH$46:$EI$46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1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Ｂ郡(BL-1M)'!$EH$1,'Ｂ郡(BL-1M)'!$EI$1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Ｂ郡(BL-1M)'!$EH$47,'Ｂ郡(BL-1M)'!$EI$47)</c:f>
              <c:numCache>
                <c:formatCode>0</c:formatCode>
                <c:ptCount val="2"/>
                <c:pt idx="0">
                  <c:v>3.5</c:v>
                </c:pt>
                <c:pt idx="1">
                  <c:v>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037-D04F-BED9-BAC5E5ADD9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49612384"/>
        <c:axId val="249612776"/>
      </c:barChart>
      <c:catAx>
        <c:axId val="24961238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49612776"/>
        <c:crosses val="autoZero"/>
        <c:auto val="1"/>
        <c:lblAlgn val="ctr"/>
        <c:lblOffset val="100"/>
        <c:noMultiLvlLbl val="0"/>
      </c:catAx>
      <c:valAx>
        <c:axId val="249612776"/>
        <c:scaling>
          <c:orientation val="minMax"/>
          <c:max val="36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49612384"/>
        <c:crosses val="autoZero"/>
        <c:crossBetween val="between"/>
        <c:majorUnit val="5"/>
        <c:minorUnit val="1.8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5400" cap="rnd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12700"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</c:marker>
          <c:dPt>
            <c:idx val="0"/>
            <c:marker>
              <c:symbol val="circle"/>
              <c:size val="6"/>
              <c:spPr>
                <a:solidFill>
                  <a:schemeClr val="tx1"/>
                </a:solidFill>
                <a:ln w="12700"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EFEE-5C44-9ED9-82B082E2621B}"/>
              </c:ext>
            </c:extLst>
          </c:dPt>
          <c:dPt>
            <c:idx val="1"/>
            <c:marker>
              <c:symbol val="circle"/>
              <c:size val="6"/>
              <c:spPr>
                <a:solidFill>
                  <a:schemeClr val="tx1"/>
                </a:solidFill>
                <a:ln w="12700"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EFEE-5C44-9ED9-82B082E2621B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C郡（BL-12M)'!$FM$37:$FN$37</c:f>
                <c:numCache>
                  <c:formatCode>General</c:formatCode>
                  <c:ptCount val="2"/>
                  <c:pt idx="0">
                    <c:v>0.41603316391727108</c:v>
                  </c:pt>
                  <c:pt idx="1">
                    <c:v>0.25806451612903242</c:v>
                  </c:pt>
                </c:numCache>
              </c:numRef>
            </c:plus>
            <c:minus>
              <c:numRef>
                <c:f>'C郡（BL-12M)'!$FM$37:$FN$37</c:f>
                <c:numCache>
                  <c:formatCode>General</c:formatCode>
                  <c:ptCount val="2"/>
                  <c:pt idx="0">
                    <c:v>0.41603316391727108</c:v>
                  </c:pt>
                  <c:pt idx="1">
                    <c:v>0.2580645161290324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C郡（BL-12M)'!$FM$2,'C郡（BL-12M)'!$FN$2)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('C郡（BL-12M)'!$FM$36,'C郡（BL-12M)'!$FN$36)</c:f>
              <c:numCache>
                <c:formatCode>0.00</c:formatCode>
                <c:ptCount val="2"/>
                <c:pt idx="0">
                  <c:v>6.967741935483871</c:v>
                </c:pt>
                <c:pt idx="1">
                  <c:v>8.7419354838709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FEE-5C44-9ED9-82B082E262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53950432"/>
        <c:axId val="453950824"/>
      </c:lineChart>
      <c:catAx>
        <c:axId val="4539504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53950824"/>
        <c:crosses val="autoZero"/>
        <c:auto val="1"/>
        <c:lblAlgn val="ctr"/>
        <c:lblOffset val="100"/>
        <c:noMultiLvlLbl val="0"/>
      </c:catAx>
      <c:valAx>
        <c:axId val="453950824"/>
        <c:scaling>
          <c:orientation val="minMax"/>
          <c:max val="12"/>
          <c:min val="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5395043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5400" cap="rnd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12700"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</c:marker>
          <c:dPt>
            <c:idx val="0"/>
            <c:marker>
              <c:symbol val="circle"/>
              <c:size val="6"/>
              <c:spPr>
                <a:solidFill>
                  <a:schemeClr val="tx1"/>
                </a:solidFill>
                <a:ln w="12700"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2B1C-C04B-B32F-44B02B6C0584}"/>
              </c:ext>
            </c:extLst>
          </c:dPt>
          <c:dPt>
            <c:idx val="1"/>
            <c:marker>
              <c:symbol val="circle"/>
              <c:size val="6"/>
              <c:spPr>
                <a:solidFill>
                  <a:schemeClr val="tx1"/>
                </a:solidFill>
                <a:ln w="12700">
                  <a:solidFill>
                    <a:schemeClr val="tx1">
                      <a:lumMod val="75000"/>
                      <a:lumOff val="25000"/>
                    </a:schemeClr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2B1C-C04B-B32F-44B02B6C0584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C郡（BL-1M)'!$FM$47:$FN$47</c:f>
                <c:numCache>
                  <c:formatCode>General</c:formatCode>
                  <c:ptCount val="2"/>
                  <c:pt idx="0">
                    <c:v>0.35619308476315964</c:v>
                  </c:pt>
                  <c:pt idx="1">
                    <c:v>0.24086656599869871</c:v>
                  </c:pt>
                </c:numCache>
              </c:numRef>
            </c:plus>
            <c:minus>
              <c:numRef>
                <c:f>'C郡（BL-1M)'!$FM$47:$FN$47</c:f>
                <c:numCache>
                  <c:formatCode>General</c:formatCode>
                  <c:ptCount val="2"/>
                  <c:pt idx="0">
                    <c:v>0.35619308476315964</c:v>
                  </c:pt>
                  <c:pt idx="1">
                    <c:v>0.2408665659986987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郡（BL-1M)'!$FM$2:$FN$2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C郡（BL-1M)'!$FM$46,'C郡（BL-1M)'!$FN$46)</c:f>
              <c:numCache>
                <c:formatCode>0.00</c:formatCode>
                <c:ptCount val="2"/>
                <c:pt idx="0">
                  <c:v>7.1904761904761907</c:v>
                </c:pt>
                <c:pt idx="1">
                  <c:v>10.0476190476190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B1C-C04B-B32F-44B02B6C05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9018232"/>
        <c:axId val="439018624"/>
      </c:lineChart>
      <c:catAx>
        <c:axId val="4390182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39018624"/>
        <c:crosses val="autoZero"/>
        <c:auto val="1"/>
        <c:lblAlgn val="ctr"/>
        <c:lblOffset val="100"/>
        <c:noMultiLvlLbl val="0"/>
      </c:catAx>
      <c:valAx>
        <c:axId val="439018624"/>
        <c:scaling>
          <c:orientation val="minMax"/>
          <c:max val="12"/>
          <c:min val="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43901823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C郡（BL-1M)'!$FD$71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C郡（BL-1M)'!$FE$72:$FH$72</c:f>
                <c:numCache>
                  <c:formatCode>General</c:formatCode>
                  <c:ptCount val="4"/>
                  <c:pt idx="0">
                    <c:v>4</c:v>
                  </c:pt>
                  <c:pt idx="1">
                    <c:v>4</c:v>
                  </c:pt>
                  <c:pt idx="2">
                    <c:v>4</c:v>
                  </c:pt>
                  <c:pt idx="3">
                    <c:v>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M)'!$FE$2,'C郡（BL-1M)'!$FF$2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C郡（BL-1M)'!$FE$71,'C郡（BL-1M)'!$FF$71)</c:f>
              <c:numCache>
                <c:formatCode>0.00_);[Red]\(0.00\)</c:formatCode>
                <c:ptCount val="2"/>
                <c:pt idx="0">
                  <c:v>18</c:v>
                </c:pt>
                <c:pt idx="1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C9-794F-AA90-F96C1058CABE}"/>
            </c:ext>
          </c:extLst>
        </c:ser>
        <c:ser>
          <c:idx val="1"/>
          <c:order val="1"/>
          <c:tx>
            <c:strRef>
              <c:f>'C郡（BL-1M)'!$FD$70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cat>
            <c:strRef>
              <c:f>('C郡（BL-1M)'!$FE$2,'C郡（BL-1M)'!$FF$2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C郡（BL-1M)'!$FE$70,'C郡（BL-1M)'!$FF$70)</c:f>
              <c:numCache>
                <c:formatCode>0.00_);[Red]\(0.00\)</c:formatCode>
                <c:ptCount val="2"/>
                <c:pt idx="0">
                  <c:v>7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C9-794F-AA90-F96C1058CABE}"/>
            </c:ext>
          </c:extLst>
        </c:ser>
        <c:ser>
          <c:idx val="0"/>
          <c:order val="2"/>
          <c:tx>
            <c:strRef>
              <c:f>'C郡（BL-1M)'!$FD$69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郡（BL-1M)'!$FE$68:$FH$68</c:f>
                <c:numCache>
                  <c:formatCode>General</c:formatCode>
                  <c:ptCount val="4"/>
                  <c:pt idx="0">
                    <c:v>11.25</c:v>
                  </c:pt>
                  <c:pt idx="1">
                    <c:v>8</c:v>
                  </c:pt>
                  <c:pt idx="2">
                    <c:v>9</c:v>
                  </c:pt>
                  <c:pt idx="3">
                    <c:v>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M)'!$FE$2,'C郡（BL-1M)'!$FF$2)</c:f>
              <c:strCache>
                <c:ptCount val="2"/>
                <c:pt idx="0">
                  <c:v>Baseline</c:v>
                </c:pt>
                <c:pt idx="1">
                  <c:v>1 month</c:v>
                </c:pt>
              </c:strCache>
            </c:strRef>
          </c:cat>
          <c:val>
            <c:numRef>
              <c:f>('C郡（BL-1M)'!$FE$69,'C郡（BL-1M)'!$FF$69)</c:f>
              <c:numCache>
                <c:formatCode>0.00_);[Red]\(0.00\)</c:formatCode>
                <c:ptCount val="2"/>
                <c:pt idx="0">
                  <c:v>3.75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6C9-794F-AA90-F96C1058CA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88026656"/>
        <c:axId val="288027832"/>
      </c:barChart>
      <c:catAx>
        <c:axId val="28802665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88027832"/>
        <c:crosses val="autoZero"/>
        <c:auto val="1"/>
        <c:lblAlgn val="ctr"/>
        <c:lblOffset val="100"/>
        <c:noMultiLvlLbl val="0"/>
      </c:catAx>
      <c:valAx>
        <c:axId val="288027832"/>
        <c:scaling>
          <c:orientation val="minMax"/>
          <c:max val="4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8802665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C郡（BL-6M) '!$FD$67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C郡（BL-6M) '!$FE$68:$FH$68</c:f>
                <c:numCache>
                  <c:formatCode>General</c:formatCode>
                  <c:ptCount val="4"/>
                  <c:pt idx="0">
                    <c:v>4</c:v>
                  </c:pt>
                  <c:pt idx="1">
                    <c:v>4.75</c:v>
                  </c:pt>
                  <c:pt idx="2">
                    <c:v>4</c:v>
                  </c:pt>
                  <c:pt idx="3">
                    <c:v>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6M) '!$FE$2,'C郡（BL-6M) '!$FG$2)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('C郡（BL-6M) '!$FE$67,'C郡（BL-6M) '!$FG$67)</c:f>
              <c:numCache>
                <c:formatCode>0.00_);[Red]\(0.00\)</c:formatCode>
                <c:ptCount val="2"/>
                <c:pt idx="0">
                  <c:v>18</c:v>
                </c:pt>
                <c:pt idx="1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61-1046-BA8A-0F0FB9211AF4}"/>
            </c:ext>
          </c:extLst>
        </c:ser>
        <c:ser>
          <c:idx val="1"/>
          <c:order val="1"/>
          <c:tx>
            <c:strRef>
              <c:f>'C郡（BL-6M) '!$FD$66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cat>
            <c:strRef>
              <c:f>('C郡（BL-6M) '!$FE$2,'C郡（BL-6M) '!$FG$2)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('C郡（BL-6M) '!$FE$66,'C郡（BL-6M) '!$FG$66)</c:f>
              <c:numCache>
                <c:formatCode>0.00_);[Red]\(0.00\)</c:formatCode>
                <c:ptCount val="2"/>
                <c:pt idx="0">
                  <c:v>6.5</c:v>
                </c:pt>
                <c:pt idx="1">
                  <c:v>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C61-1046-BA8A-0F0FB9211AF4}"/>
            </c:ext>
          </c:extLst>
        </c:ser>
        <c:ser>
          <c:idx val="0"/>
          <c:order val="2"/>
          <c:tx>
            <c:strRef>
              <c:f>'C郡（BL-6M) '!$FD$65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郡（BL-6M) '!$FE$64:$FH$64</c:f>
                <c:numCache>
                  <c:formatCode>General</c:formatCode>
                  <c:ptCount val="4"/>
                  <c:pt idx="0">
                    <c:v>12</c:v>
                  </c:pt>
                  <c:pt idx="1">
                    <c:v>7.75</c:v>
                  </c:pt>
                  <c:pt idx="2">
                    <c:v>9</c:v>
                  </c:pt>
                  <c:pt idx="3">
                    <c:v>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6M) '!$FE$2,'C郡（BL-6M) '!$FG$2)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('C郡（BL-6M) '!$FE$65,'C郡（BL-6M) '!$FG$65)</c:f>
              <c:numCache>
                <c:formatCode>0.00_);[Red]\(0.00\)</c:formatCode>
                <c:ptCount val="2"/>
                <c:pt idx="0">
                  <c:v>3.5</c:v>
                </c:pt>
                <c:pt idx="1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C61-1046-BA8A-0F0FB9211A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90368304"/>
        <c:axId val="290368696"/>
      </c:barChart>
      <c:catAx>
        <c:axId val="29036830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90368696"/>
        <c:crosses val="autoZero"/>
        <c:auto val="1"/>
        <c:lblAlgn val="ctr"/>
        <c:lblOffset val="100"/>
        <c:noMultiLvlLbl val="0"/>
      </c:catAx>
      <c:valAx>
        <c:axId val="290368696"/>
        <c:scaling>
          <c:orientation val="minMax"/>
          <c:max val="4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90368304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６M) '!$EG$46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６M) '!$EH$47:$EI$47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６M) '!$EH$1:$EI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H$46:$EI$46</c:f>
              <c:numCache>
                <c:formatCode>0.00</c:formatCode>
                <c:ptCount val="2"/>
                <c:pt idx="0">
                  <c:v>20</c:v>
                </c:pt>
                <c:pt idx="1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87-4949-8F15-0522CE87F95E}"/>
            </c:ext>
          </c:extLst>
        </c:ser>
        <c:ser>
          <c:idx val="1"/>
          <c:order val="1"/>
          <c:tx>
            <c:strRef>
              <c:f>'Ｂ郡(BL-６M) '!$EG$45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Ｂ郡(BL-６M) '!$EH$1:$EI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H$45:$EI$45</c:f>
              <c:numCache>
                <c:formatCode>0.00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87-4949-8F15-0522CE87F95E}"/>
            </c:ext>
          </c:extLst>
        </c:ser>
        <c:ser>
          <c:idx val="0"/>
          <c:order val="2"/>
          <c:tx>
            <c:strRef>
              <c:f>'Ｂ郡(BL-６M) '!$EG$44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６M) '!$EH$43:$EI$43</c:f>
                <c:numCache>
                  <c:formatCode>General</c:formatCode>
                  <c:ptCount val="2"/>
                  <c:pt idx="0">
                    <c:v>9</c:v>
                  </c:pt>
                  <c:pt idx="1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６M) '!$EH$1:$EI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H$44:$EI$44</c:f>
              <c:numCache>
                <c:formatCode>0.00</c:formatCode>
                <c:ptCount val="2"/>
                <c:pt idx="0">
                  <c:v>1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387-4949-8F15-0522CE87F9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90369480"/>
        <c:axId val="290369872"/>
      </c:barChart>
      <c:catAx>
        <c:axId val="2903694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90369872"/>
        <c:crosses val="autoZero"/>
        <c:auto val="1"/>
        <c:lblAlgn val="ctr"/>
        <c:lblOffset val="100"/>
        <c:noMultiLvlLbl val="0"/>
      </c:catAx>
      <c:valAx>
        <c:axId val="290369872"/>
        <c:scaling>
          <c:orientation val="minMax"/>
          <c:max val="4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90369480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６M) '!$EG$61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６M) '!$EH$62:$EI$62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６M) '!$EH$1:$EI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H$61:$EI$61</c:f>
              <c:numCache>
                <c:formatCode>0.00</c:formatCode>
                <c:ptCount val="2"/>
                <c:pt idx="0">
                  <c:v>19</c:v>
                </c:pt>
                <c:pt idx="1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BE-F343-8F9C-64965C91A539}"/>
            </c:ext>
          </c:extLst>
        </c:ser>
        <c:ser>
          <c:idx val="1"/>
          <c:order val="1"/>
          <c:tx>
            <c:strRef>
              <c:f>'Ｂ郡(BL-６M) '!$EG$60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Ｂ郡(BL-６M) '!$EH$1:$EI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H$60:$EI$60</c:f>
              <c:numCache>
                <c:formatCode>0.00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BE-F343-8F9C-64965C91A539}"/>
            </c:ext>
          </c:extLst>
        </c:ser>
        <c:ser>
          <c:idx val="0"/>
          <c:order val="2"/>
          <c:tx>
            <c:strRef>
              <c:f>'Ｂ郡(BL-６M) '!$EG$59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６M) '!$EH$58:$EI$58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６M) '!$EH$1:$EI$1</c:f>
              <c:strCache>
                <c:ptCount val="2"/>
                <c:pt idx="0">
                  <c:v>Baseline</c:v>
                </c:pt>
                <c:pt idx="1">
                  <c:v>6 months</c:v>
                </c:pt>
              </c:strCache>
            </c:strRef>
          </c:cat>
          <c:val>
            <c:numRef>
              <c:f>'Ｂ郡(BL-６M) '!$EH$59:$EI$59</c:f>
              <c:numCache>
                <c:formatCode>0.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CBE-F343-8F9C-64965C91A5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90370656"/>
        <c:axId val="290371048"/>
      </c:barChart>
      <c:catAx>
        <c:axId val="29037065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90371048"/>
        <c:crosses val="autoZero"/>
        <c:auto val="1"/>
        <c:lblAlgn val="ctr"/>
        <c:lblOffset val="100"/>
        <c:noMultiLvlLbl val="0"/>
      </c:catAx>
      <c:valAx>
        <c:axId val="290371048"/>
        <c:scaling>
          <c:orientation val="minMax"/>
          <c:max val="3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9037065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C郡（BL-12M)'!$FD$60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C郡（BL-12M)'!$FE$61:$FH$61</c:f>
                <c:numCache>
                  <c:formatCode>General</c:formatCode>
                  <c:ptCount val="4"/>
                  <c:pt idx="0">
                    <c:v>4</c:v>
                  </c:pt>
                  <c:pt idx="1">
                    <c:v>6</c:v>
                  </c:pt>
                  <c:pt idx="2">
                    <c:v>4</c:v>
                  </c:pt>
                  <c:pt idx="3">
                    <c:v>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2M)'!$FE$2,'C郡（BL-12M)'!$FH$2)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('C郡（BL-12M)'!$FE$60,'C郡（BL-12M)'!$FH$60)</c:f>
              <c:numCache>
                <c:formatCode>0.00_);[Red]\(0.00\)</c:formatCode>
                <c:ptCount val="2"/>
                <c:pt idx="0">
                  <c:v>18</c:v>
                </c:pt>
                <c:pt idx="1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F8-274A-B169-200B3EBAE67E}"/>
            </c:ext>
          </c:extLst>
        </c:ser>
        <c:ser>
          <c:idx val="1"/>
          <c:order val="1"/>
          <c:tx>
            <c:strRef>
              <c:f>'C郡（BL-12M)'!$FD$59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cat>
            <c:strRef>
              <c:f>('C郡（BL-12M)'!$FE$2,'C郡（BL-12M)'!$FH$2)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('C郡（BL-12M)'!$FE$59,'C郡（BL-12M)'!$FH$59)</c:f>
              <c:numCache>
                <c:formatCode>0.00_);[Red]\(0.00\)</c:formatCode>
                <c:ptCount val="2"/>
                <c:pt idx="0">
                  <c:v>4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CF8-274A-B169-200B3EBAE67E}"/>
            </c:ext>
          </c:extLst>
        </c:ser>
        <c:ser>
          <c:idx val="0"/>
          <c:order val="2"/>
          <c:tx>
            <c:strRef>
              <c:f>'C郡（BL-12M)'!$FD$58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郡（BL-12M)'!$FE$57:$FH$57</c:f>
                <c:numCache>
                  <c:formatCode>General</c:formatCode>
                  <c:ptCount val="4"/>
                  <c:pt idx="0">
                    <c:v>12</c:v>
                  </c:pt>
                  <c:pt idx="1">
                    <c:v>7</c:v>
                  </c:pt>
                  <c:pt idx="2">
                    <c:v>9</c:v>
                  </c:pt>
                  <c:pt idx="3">
                    <c:v>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C郡（BL-12M)'!$FE$2,'C郡（BL-12M)'!$FH$2)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('C郡（BL-12M)'!$FE$58,'C郡（BL-12M)'!$FH$58)</c:f>
              <c:numCache>
                <c:formatCode>0.00_);[Red]\(0.00\)</c:formatCode>
                <c:ptCount val="2"/>
                <c:pt idx="0">
                  <c:v>6</c:v>
                </c:pt>
                <c:pt idx="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CF8-274A-B169-200B3EBAE6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90491776"/>
        <c:axId val="290492168"/>
      </c:barChart>
      <c:catAx>
        <c:axId val="2904917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90492168"/>
        <c:crosses val="autoZero"/>
        <c:auto val="1"/>
        <c:lblAlgn val="ctr"/>
        <c:lblOffset val="100"/>
        <c:noMultiLvlLbl val="0"/>
      </c:catAx>
      <c:valAx>
        <c:axId val="290492168"/>
        <c:scaling>
          <c:orientation val="minMax"/>
          <c:max val="4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9049177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Century" panose="020406040505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12M) '!$EG$46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12M) '!$EH$47:$EI$47</c:f>
                <c:numCache>
                  <c:formatCode>General</c:formatCode>
                  <c:ptCount val="2"/>
                  <c:pt idx="0">
                    <c:v>1</c:v>
                  </c:pt>
                  <c:pt idx="1">
                    <c:v>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2M) '!$EH$1:$EI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H$46:$EI$46</c:f>
              <c:numCache>
                <c:formatCode>0.00</c:formatCode>
                <c:ptCount val="2"/>
                <c:pt idx="0">
                  <c:v>20</c:v>
                </c:pt>
                <c:pt idx="1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E1-1C4D-BD8B-FB98FEAA1997}"/>
            </c:ext>
          </c:extLst>
        </c:ser>
        <c:ser>
          <c:idx val="1"/>
          <c:order val="1"/>
          <c:tx>
            <c:strRef>
              <c:f>'Ｂ郡(BL-12M) '!$EG$45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Ｂ郡(BL-12M) '!$EH$1:$EI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H$45:$EI$45</c:f>
              <c:numCache>
                <c:formatCode>0.00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E1-1C4D-BD8B-FB98FEAA1997}"/>
            </c:ext>
          </c:extLst>
        </c:ser>
        <c:ser>
          <c:idx val="0"/>
          <c:order val="2"/>
          <c:tx>
            <c:strRef>
              <c:f>'Ｂ郡(BL-12M) '!$EG$44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12M) '!$EH$43:$EI$43</c:f>
                <c:numCache>
                  <c:formatCode>General</c:formatCode>
                  <c:ptCount val="2"/>
                  <c:pt idx="0">
                    <c:v>9</c:v>
                  </c:pt>
                  <c:pt idx="1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2M) '!$EH$1:$EI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H$44:$EI$44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9E1-1C4D-BD8B-FB98FEAA19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90492952"/>
        <c:axId val="290493344"/>
      </c:barChart>
      <c:catAx>
        <c:axId val="2904929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90493344"/>
        <c:crosses val="autoZero"/>
        <c:auto val="1"/>
        <c:lblAlgn val="ctr"/>
        <c:lblOffset val="100"/>
        <c:noMultiLvlLbl val="0"/>
      </c:catAx>
      <c:valAx>
        <c:axId val="290493344"/>
        <c:scaling>
          <c:orientation val="minMax"/>
          <c:max val="35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9049295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2"/>
          <c:order val="0"/>
          <c:tx>
            <c:strRef>
              <c:f>'Ｂ郡(BL-12M) '!$EG$61</c:f>
              <c:strCache>
                <c:ptCount val="1"/>
                <c:pt idx="0">
                  <c:v>25%</c:v>
                </c:pt>
              </c:strCache>
            </c:strRef>
          </c:tx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'Ｂ郡(BL-12M) '!$EH$62:$EI$62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2M) '!$EH$1:$EI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H$61:$EI$61</c:f>
              <c:numCache>
                <c:formatCode>0.00</c:formatCode>
                <c:ptCount val="2"/>
                <c:pt idx="0">
                  <c:v>19</c:v>
                </c:pt>
                <c:pt idx="1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3A-6E4F-A120-40D85293C798}"/>
            </c:ext>
          </c:extLst>
        </c:ser>
        <c:ser>
          <c:idx val="1"/>
          <c:order val="1"/>
          <c:tx>
            <c:strRef>
              <c:f>'Ｂ郡(BL-12M) '!$EG$60</c:f>
              <c:strCache>
                <c:ptCount val="1"/>
                <c:pt idx="0">
                  <c:v>中央値-25%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Ｂ郡(BL-12M) '!$EH$1:$EI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H$60:$EI$60</c:f>
              <c:numCache>
                <c:formatCode>0.00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03A-6E4F-A120-40D85293C798}"/>
            </c:ext>
          </c:extLst>
        </c:ser>
        <c:ser>
          <c:idx val="0"/>
          <c:order val="2"/>
          <c:tx>
            <c:strRef>
              <c:f>'Ｂ郡(BL-12M) '!$EG$59</c:f>
              <c:strCache>
                <c:ptCount val="1"/>
                <c:pt idx="0">
                  <c:v>75%-中央値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Ｂ郡(BL-12M) '!$EH$58:$EI$58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Ｂ郡(BL-12M) '!$EH$1:$EI$1</c:f>
              <c:strCache>
                <c:ptCount val="2"/>
                <c:pt idx="0">
                  <c:v>Baseline</c:v>
                </c:pt>
                <c:pt idx="1">
                  <c:v>12 months</c:v>
                </c:pt>
              </c:strCache>
            </c:strRef>
          </c:cat>
          <c:val>
            <c:numRef>
              <c:f>'Ｂ郡(BL-12M) '!$EH$59:$EI$59</c:f>
              <c:numCache>
                <c:formatCode>0.00</c:formatCode>
                <c:ptCount val="2"/>
                <c:pt idx="0">
                  <c:v>0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03A-6E4F-A120-40D85293C7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100"/>
        <c:axId val="290494128"/>
        <c:axId val="290494520"/>
      </c:barChart>
      <c:catAx>
        <c:axId val="29049412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90494520"/>
        <c:crosses val="autoZero"/>
        <c:auto val="1"/>
        <c:lblAlgn val="ctr"/>
        <c:lblOffset val="100"/>
        <c:noMultiLvlLbl val="0"/>
      </c:catAx>
      <c:valAx>
        <c:axId val="290494520"/>
        <c:scaling>
          <c:orientation val="minMax"/>
          <c:max val="30"/>
          <c:min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entury" panose="02040604050505020304" pitchFamily="18" charset="0"/>
                <a:ea typeface="+mn-ea"/>
                <a:cs typeface="+mn-cs"/>
              </a:defRPr>
            </a:pPr>
            <a:endParaRPr lang="ja-JP"/>
          </a:p>
        </c:txPr>
        <c:crossAx val="290494128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7EFE4C-CDB0-F544-8594-5C02EA8DAB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002BCAB-6DDD-D14E-8FB9-6654D173F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668392-BA5F-E240-A803-FE2F6FDBD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EDC866-6640-7640-860C-45DCBEA02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763A84-DDAD-D34B-BF5A-F75000E7B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544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1D394-5C9E-B742-8A30-7273DCC26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B696EE-E11E-E949-AC38-83FCCC90DC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87A105-4380-F04A-978E-6F9900AE1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F194B4-5338-C640-B77C-05201882A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99D94B-8A11-0B4D-8421-EE466D3E2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699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9F2B775-8ACF-1845-BC00-9566AB8497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4C3CB40-1CAB-6946-8A6D-6EBC38E9E7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C9AA47-E68F-F342-B79B-C238BF25B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6F20DB-88E1-0944-90FB-C0FDD0805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A7FB93-65B1-2243-8EF1-5C89BE582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5278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2A8D97-0D4A-5D42-88C8-28E409C32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F5DBB8E-A75E-7C4C-A99B-1AF96C94D3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D0CE93-1391-F74D-B62B-5D55A06CC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578279-0408-4047-A5BF-08BA3C4DC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6F9394-065D-A945-B8B5-1AA8C46A7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53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BFEE4F-BD87-854A-A2AF-7EF627C38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DBE553-70FF-EB4E-A09D-203A772215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E6DFFC-A35A-D941-A969-73B96FFC6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9C832E-B088-7D43-9339-15EC026D6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DD1660-4791-8641-9796-00AEC1156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1092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3F6F6B-A21D-5643-9B2C-56DE335A88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157AB10-65DE-BA4A-AD97-E6280D1313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2EE1CB-15D0-DF4F-95D8-7DA61F254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B49F9B-8A57-6046-9F77-20D8EA8D5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1EB56AF-CBF3-2442-815B-B9F381F806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4D8BB3-89E4-6846-8E9E-5A2C5E651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037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27716C-178B-6C49-9298-9CA809109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AAEFBEA-85DC-CC46-930F-C168E4D9B6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7F24462-0A00-FF43-8D9F-D0AEDAE8CD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2A0ECF4-C64F-614A-B275-2172E4E158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802306C-21F8-4B47-8739-43D99F9435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99BACF6-7577-E34C-A104-283D419B8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D9433D6-4E06-D343-8BD4-A6E47785F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01A7B0A-4219-4E4D-8FEF-8CABDB95A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1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7DB4E1-061E-484B-A7DB-10E29AA4D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292E82C-503A-6849-8C33-F4F9B6649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D532006-2102-0C40-98D8-9C197C8D0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47D4043-3EF2-0844-AA95-248DFE36E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323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C1FD21C-0DE5-6D45-871E-DC2A70EA7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F5B6D72-D9DE-AD42-ACB0-8DE730AB8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A8216CB-B8C5-254A-AA54-52F895588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79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743581-3A78-1D4A-AA2F-BFBFF06919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74AB475-A9E1-9F47-9DF8-6704A86042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033C000-6E32-3B4A-91A5-F59CCB102F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721FB57-4487-7244-9332-CFFEDCDC3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28666C-6642-FF40-B70E-D616DA046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2E7409B-8409-E44A-9AC0-B21D3DC19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8176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D23245-6B4B-FB41-B237-6E20A7D1F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F3EC4AA-E774-164C-B7B3-C12085E900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BAE8AE8-EE61-0143-8236-B2B8E49F8F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DD62308-0FE8-7F4A-A722-CA73E92C5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D10783B-E848-094D-B574-C598413F5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D99FAD1-217C-1344-9053-9C80920BB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128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16C089A-A9C1-D64B-BD77-72DA3EF05B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DE5DED9-A40D-4647-B310-51A1E28558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40A2C4-A214-384C-9FF0-7129340228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E005F-1DD0-0044-A947-859C4F94F902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FF53E1C-ECAB-594F-AC56-A13AA94E5B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A3CC89-EFE8-494C-A5BD-68B96E3B48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04AA8-0474-A742-A8AE-2C39186E7A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7660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7" Type="http://schemas.openxmlformats.org/officeDocument/2006/relationships/chart" Target="../charts/chart21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0.xml"/><Relationship Id="rId5" Type="http://schemas.openxmlformats.org/officeDocument/2006/relationships/chart" Target="../charts/chart19.xml"/><Relationship Id="rId4" Type="http://schemas.openxmlformats.org/officeDocument/2006/relationships/chart" Target="../charts/char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id="{9B04E1C1-A61C-2A45-B209-BBFC53F0D585}"/>
              </a:ext>
            </a:extLst>
          </p:cNvPr>
          <p:cNvGrpSpPr/>
          <p:nvPr/>
        </p:nvGrpSpPr>
        <p:grpSpPr>
          <a:xfrm>
            <a:off x="199663" y="307564"/>
            <a:ext cx="5750605" cy="3158635"/>
            <a:chOff x="369635" y="220880"/>
            <a:chExt cx="5750605" cy="3158635"/>
          </a:xfrm>
        </p:grpSpPr>
        <p:graphicFrame>
          <p:nvGraphicFramePr>
            <p:cNvPr id="9" name="グラフ 8">
              <a:extLst>
                <a:ext uri="{FF2B5EF4-FFF2-40B4-BE49-F238E27FC236}">
                  <a16:creationId xmlns:a16="http://schemas.microsoft.com/office/drawing/2014/main" id="{DB2D9D21-1022-2740-B6C8-2A47B8FD9FA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11059059"/>
                </p:ext>
              </p:extLst>
            </p:nvPr>
          </p:nvGraphicFramePr>
          <p:xfrm>
            <a:off x="616211" y="1147264"/>
            <a:ext cx="1391738" cy="170773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C711E64D-2190-7741-BF9D-EA458B202019}"/>
                </a:ext>
              </a:extLst>
            </p:cNvPr>
            <p:cNvSpPr/>
            <p:nvPr/>
          </p:nvSpPr>
          <p:spPr>
            <a:xfrm>
              <a:off x="417453" y="513501"/>
              <a:ext cx="5656776" cy="2866014"/>
            </a:xfrm>
            <a:prstGeom prst="rect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5D672688-DAD4-7443-9952-8AE6734A24D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91483233"/>
                </p:ext>
              </p:extLst>
            </p:nvPr>
          </p:nvGraphicFramePr>
          <p:xfrm>
            <a:off x="2339348" y="1041777"/>
            <a:ext cx="1624303" cy="19035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9249A493-6CAE-F448-985B-D869DBB2F6EB}"/>
                </a:ext>
              </a:extLst>
            </p:cNvPr>
            <p:cNvSpPr txBox="1"/>
            <p:nvPr/>
          </p:nvSpPr>
          <p:spPr>
            <a:xfrm>
              <a:off x="477413" y="634552"/>
              <a:ext cx="18838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mentary school children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6646A457-DCCA-4A45-9EF3-4B7473A0A048}"/>
                </a:ext>
              </a:extLst>
            </p:cNvPr>
            <p:cNvSpPr txBox="1"/>
            <p:nvPr/>
          </p:nvSpPr>
          <p:spPr>
            <a:xfrm>
              <a:off x="2255976" y="618383"/>
              <a:ext cx="18662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unior high school students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824DEE97-5D69-3440-A278-EA663E82C573}"/>
                </a:ext>
              </a:extLst>
            </p:cNvPr>
            <p:cNvSpPr txBox="1"/>
            <p:nvPr/>
          </p:nvSpPr>
          <p:spPr>
            <a:xfrm>
              <a:off x="4090517" y="628728"/>
              <a:ext cx="20297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olescents and young adults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6CD24C4-23A2-D240-8D47-BDBBE63C82DE}"/>
                </a:ext>
              </a:extLst>
            </p:cNvPr>
            <p:cNvSpPr txBox="1"/>
            <p:nvPr/>
          </p:nvSpPr>
          <p:spPr>
            <a:xfrm>
              <a:off x="801448" y="3003270"/>
              <a:ext cx="1356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1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6" name="グラフ 15">
              <a:extLst>
                <a:ext uri="{FF2B5EF4-FFF2-40B4-BE49-F238E27FC236}">
                  <a16:creationId xmlns:a16="http://schemas.microsoft.com/office/drawing/2014/main" id="{68B17A72-7AD1-5C48-8BCC-FE4CFE76DC8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60188221"/>
                </p:ext>
              </p:extLst>
            </p:nvPr>
          </p:nvGraphicFramePr>
          <p:xfrm>
            <a:off x="4163009" y="1063793"/>
            <a:ext cx="1656015" cy="18890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89D8A0A5-FAA0-844A-8DAC-375B24C3DFD7}"/>
                </a:ext>
              </a:extLst>
            </p:cNvPr>
            <p:cNvSpPr txBox="1"/>
            <p:nvPr/>
          </p:nvSpPr>
          <p:spPr>
            <a:xfrm>
              <a:off x="2602876" y="3015845"/>
              <a:ext cx="128592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1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E84AB34-D9F1-184F-965F-AE5923A6B8FB}"/>
                </a:ext>
              </a:extLst>
            </p:cNvPr>
            <p:cNvSpPr txBox="1"/>
            <p:nvPr/>
          </p:nvSpPr>
          <p:spPr>
            <a:xfrm>
              <a:off x="4389562" y="3035361"/>
              <a:ext cx="128592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1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523337BA-F931-8E4C-B013-554D21916A40}"/>
                </a:ext>
              </a:extLst>
            </p:cNvPr>
            <p:cNvSpPr txBox="1"/>
            <p:nvPr/>
          </p:nvSpPr>
          <p:spPr>
            <a:xfrm>
              <a:off x="1099379" y="825711"/>
              <a:ext cx="6399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1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60DD071E-7474-C346-AA9A-6AFFC89E9E50}"/>
                </a:ext>
              </a:extLst>
            </p:cNvPr>
            <p:cNvSpPr txBox="1"/>
            <p:nvPr/>
          </p:nvSpPr>
          <p:spPr>
            <a:xfrm>
              <a:off x="2882699" y="838967"/>
              <a:ext cx="6399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0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F2E4463C-EFE3-7F41-A7BA-FF3872C69E5A}"/>
                </a:ext>
              </a:extLst>
            </p:cNvPr>
            <p:cNvSpPr txBox="1"/>
            <p:nvPr/>
          </p:nvSpPr>
          <p:spPr>
            <a:xfrm>
              <a:off x="4673727" y="841504"/>
              <a:ext cx="6399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42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" name="グループ化 21">
              <a:extLst>
                <a:ext uri="{FF2B5EF4-FFF2-40B4-BE49-F238E27FC236}">
                  <a16:creationId xmlns:a16="http://schemas.microsoft.com/office/drawing/2014/main" id="{E23FC7B6-6A5E-D74E-82FE-56C070DE1784}"/>
                </a:ext>
              </a:extLst>
            </p:cNvPr>
            <p:cNvGrpSpPr/>
            <p:nvPr/>
          </p:nvGrpSpPr>
          <p:grpSpPr>
            <a:xfrm>
              <a:off x="4813022" y="2626090"/>
              <a:ext cx="556695" cy="47713"/>
              <a:chOff x="2616729" y="5879433"/>
              <a:chExt cx="864000" cy="75175"/>
            </a:xfrm>
          </p:grpSpPr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361CEE94-81FB-7449-AB2A-84C0F97598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id="{66721EBF-CCCA-974E-BA04-0B3132FDA7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id="{19168647-9BC1-8E47-8C0C-2C9AF5A15C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460595DC-6796-2047-BB89-1DD11F25D902}"/>
                </a:ext>
              </a:extLst>
            </p:cNvPr>
            <p:cNvGrpSpPr/>
            <p:nvPr/>
          </p:nvGrpSpPr>
          <p:grpSpPr>
            <a:xfrm>
              <a:off x="1174617" y="2326974"/>
              <a:ext cx="556695" cy="47713"/>
              <a:chOff x="2616729" y="5879433"/>
              <a:chExt cx="864000" cy="75175"/>
            </a:xfrm>
          </p:grpSpPr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id="{779512F4-7361-8D4D-917A-09E8DD24E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14D9B112-49FF-4B4B-9EC8-18AFB842C3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id="{7DC8A178-F37B-7D40-AFDD-5A1E2366CE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2D9FE53A-379A-C249-BD2B-06B5FCFB093F}"/>
                </a:ext>
              </a:extLst>
            </p:cNvPr>
            <p:cNvGrpSpPr/>
            <p:nvPr/>
          </p:nvGrpSpPr>
          <p:grpSpPr>
            <a:xfrm>
              <a:off x="3007772" y="2310007"/>
              <a:ext cx="556695" cy="47713"/>
              <a:chOff x="2616729" y="5879433"/>
              <a:chExt cx="864000" cy="75175"/>
            </a:xfrm>
          </p:grpSpPr>
          <p:cxnSp>
            <p:nvCxnSpPr>
              <p:cNvPr id="26" name="直線コネクタ 25">
                <a:extLst>
                  <a:ext uri="{FF2B5EF4-FFF2-40B4-BE49-F238E27FC236}">
                    <a16:creationId xmlns:a16="http://schemas.microsoft.com/office/drawing/2014/main" id="{7E871859-B8B3-7445-9788-DE26E91678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6ACAE6A7-FB69-D847-A4A1-49C2688DC6A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B0814C4F-445F-164F-B3E5-A9FBE51E40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A565E1CE-B56E-8249-B6B5-59D819822D70}"/>
                </a:ext>
              </a:extLst>
            </p:cNvPr>
            <p:cNvSpPr/>
            <p:nvPr/>
          </p:nvSpPr>
          <p:spPr>
            <a:xfrm>
              <a:off x="369635" y="220880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10B5AF65-8101-B346-BF66-194D48588602}"/>
                </a:ext>
              </a:extLst>
            </p:cNvPr>
            <p:cNvSpPr txBox="1"/>
            <p:nvPr/>
          </p:nvSpPr>
          <p:spPr>
            <a:xfrm>
              <a:off x="1146896" y="2407026"/>
              <a:ext cx="6655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8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0BD8E5AF-2E08-684A-A4E5-32223A695B91}"/>
                </a:ext>
              </a:extLst>
            </p:cNvPr>
            <p:cNvSpPr txBox="1"/>
            <p:nvPr/>
          </p:nvSpPr>
          <p:spPr>
            <a:xfrm>
              <a:off x="4782411" y="2641541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</a:t>
              </a:r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1</a:t>
              </a:r>
              <a:r>
                <a:rPr lang="ja-JP" altLang="ja-JP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856E691-6D65-2B44-A101-3BB989544E5C}"/>
                </a:ext>
              </a:extLst>
            </p:cNvPr>
            <p:cNvSpPr txBox="1"/>
            <p:nvPr/>
          </p:nvSpPr>
          <p:spPr>
            <a:xfrm>
              <a:off x="2994060" y="2379727"/>
              <a:ext cx="6655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3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FC8A315F-CEE3-0B4A-B4F0-BF0A4E080F86}"/>
              </a:ext>
            </a:extLst>
          </p:cNvPr>
          <p:cNvGrpSpPr/>
          <p:nvPr/>
        </p:nvGrpSpPr>
        <p:grpSpPr>
          <a:xfrm>
            <a:off x="6224456" y="366940"/>
            <a:ext cx="5779304" cy="3148042"/>
            <a:chOff x="6242197" y="224281"/>
            <a:chExt cx="5779304" cy="3148042"/>
          </a:xfrm>
        </p:grpSpPr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0CD139C0-75AB-1940-B898-66BF2C30A479}"/>
                </a:ext>
              </a:extLst>
            </p:cNvPr>
            <p:cNvSpPr/>
            <p:nvPr/>
          </p:nvSpPr>
          <p:spPr>
            <a:xfrm>
              <a:off x="6348750" y="489162"/>
              <a:ext cx="5649301" cy="2883161"/>
            </a:xfrm>
            <a:prstGeom prst="rect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013B0CF5-BF91-D54B-B148-84AC65FA6B26}"/>
                </a:ext>
              </a:extLst>
            </p:cNvPr>
            <p:cNvSpPr txBox="1"/>
            <p:nvPr/>
          </p:nvSpPr>
          <p:spPr>
            <a:xfrm>
              <a:off x="6412233" y="596632"/>
              <a:ext cx="18838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mentary school children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21249A06-7518-8242-8185-14A78AB9886B}"/>
                </a:ext>
              </a:extLst>
            </p:cNvPr>
            <p:cNvSpPr txBox="1"/>
            <p:nvPr/>
          </p:nvSpPr>
          <p:spPr>
            <a:xfrm>
              <a:off x="8181781" y="585415"/>
              <a:ext cx="18662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unior high school students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53566692-3150-AF4C-86E4-CB0E47C24AF5}"/>
                </a:ext>
              </a:extLst>
            </p:cNvPr>
            <p:cNvSpPr txBox="1"/>
            <p:nvPr/>
          </p:nvSpPr>
          <p:spPr>
            <a:xfrm>
              <a:off x="9991778" y="602088"/>
              <a:ext cx="20297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olescents and young adults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7874A06D-B8FA-2242-A752-FDF1907DD21D}"/>
                </a:ext>
              </a:extLst>
            </p:cNvPr>
            <p:cNvSpPr txBox="1"/>
            <p:nvPr/>
          </p:nvSpPr>
          <p:spPr>
            <a:xfrm>
              <a:off x="6658829" y="3036202"/>
              <a:ext cx="1426994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6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5D3F92E5-10F2-524C-A4D1-8D9C590DEAB3}"/>
                </a:ext>
              </a:extLst>
            </p:cNvPr>
            <p:cNvSpPr txBox="1"/>
            <p:nvPr/>
          </p:nvSpPr>
          <p:spPr>
            <a:xfrm>
              <a:off x="8556275" y="3047719"/>
              <a:ext cx="1426994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6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5A42252E-A968-5C47-BBA7-64F6011E4BFE}"/>
                </a:ext>
              </a:extLst>
            </p:cNvPr>
            <p:cNvSpPr txBox="1"/>
            <p:nvPr/>
          </p:nvSpPr>
          <p:spPr>
            <a:xfrm>
              <a:off x="10298725" y="3060151"/>
              <a:ext cx="1426994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6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8786BA1-69AC-B848-8741-86D62D19B9B5}"/>
                </a:ext>
              </a:extLst>
            </p:cNvPr>
            <p:cNvSpPr txBox="1"/>
            <p:nvPr/>
          </p:nvSpPr>
          <p:spPr>
            <a:xfrm>
              <a:off x="6988189" y="823050"/>
              <a:ext cx="569387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9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51A0022D-A7D9-8642-A3DA-63E6ACF268A6}"/>
                </a:ext>
              </a:extLst>
            </p:cNvPr>
            <p:cNvSpPr txBox="1"/>
            <p:nvPr/>
          </p:nvSpPr>
          <p:spPr>
            <a:xfrm>
              <a:off x="8827296" y="836176"/>
              <a:ext cx="569387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9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9F883158-67A2-5B4F-90AB-0A68B773C6BA}"/>
                </a:ext>
              </a:extLst>
            </p:cNvPr>
            <p:cNvSpPr txBox="1"/>
            <p:nvPr/>
          </p:nvSpPr>
          <p:spPr>
            <a:xfrm>
              <a:off x="10624721" y="809064"/>
              <a:ext cx="639919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38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46" name="グラフ 45">
              <a:extLst>
                <a:ext uri="{FF2B5EF4-FFF2-40B4-BE49-F238E27FC236}">
                  <a16:creationId xmlns:a16="http://schemas.microsoft.com/office/drawing/2014/main" id="{A1B05668-84D5-CC4D-83C7-4B4D478AE67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60926416"/>
                </p:ext>
              </p:extLst>
            </p:nvPr>
          </p:nvGraphicFramePr>
          <p:xfrm>
            <a:off x="10047998" y="1069649"/>
            <a:ext cx="1677721" cy="18904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47" name="グラフ 46">
              <a:extLst>
                <a:ext uri="{FF2B5EF4-FFF2-40B4-BE49-F238E27FC236}">
                  <a16:creationId xmlns:a16="http://schemas.microsoft.com/office/drawing/2014/main" id="{084DA1B4-2D48-8F4B-8563-68A553D2AD0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18070436"/>
                </p:ext>
              </p:extLst>
            </p:nvPr>
          </p:nvGraphicFramePr>
          <p:xfrm>
            <a:off x="8224669" y="1063793"/>
            <a:ext cx="1611050" cy="19227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48" name="グラフ 47">
              <a:extLst>
                <a:ext uri="{FF2B5EF4-FFF2-40B4-BE49-F238E27FC236}">
                  <a16:creationId xmlns:a16="http://schemas.microsoft.com/office/drawing/2014/main" id="{CA5AC3B1-87B8-D84A-97AB-80BA427E246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6058606"/>
                </p:ext>
              </p:extLst>
            </p:nvPr>
          </p:nvGraphicFramePr>
          <p:xfrm>
            <a:off x="6508115" y="1070816"/>
            <a:ext cx="1437406" cy="18892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D7BFE24D-B0E4-E746-A9BE-B8376AA2D02B}"/>
                </a:ext>
              </a:extLst>
            </p:cNvPr>
            <p:cNvGrpSpPr/>
            <p:nvPr/>
          </p:nvGrpSpPr>
          <p:grpSpPr>
            <a:xfrm>
              <a:off x="7084845" y="2443927"/>
              <a:ext cx="574962" cy="53469"/>
              <a:chOff x="2616729" y="5879433"/>
              <a:chExt cx="864000" cy="75175"/>
            </a:xfrm>
          </p:grpSpPr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B2BD35B8-CE1E-104E-832E-2A8404A462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>
                <a:extLst>
                  <a:ext uri="{FF2B5EF4-FFF2-40B4-BE49-F238E27FC236}">
                    <a16:creationId xmlns:a16="http://schemas.microsoft.com/office/drawing/2014/main" id="{DA348B71-2389-F046-BF23-77E9E5EAF0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63">
                <a:extLst>
                  <a:ext uri="{FF2B5EF4-FFF2-40B4-BE49-F238E27FC236}">
                    <a16:creationId xmlns:a16="http://schemas.microsoft.com/office/drawing/2014/main" id="{3F7685AE-8D12-954D-9D38-64BC51829A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6EBFC7EB-CB08-A640-BD29-69509C633321}"/>
                </a:ext>
              </a:extLst>
            </p:cNvPr>
            <p:cNvGrpSpPr/>
            <p:nvPr/>
          </p:nvGrpSpPr>
          <p:grpSpPr>
            <a:xfrm>
              <a:off x="8888740" y="2537500"/>
              <a:ext cx="574962" cy="53469"/>
              <a:chOff x="2616729" y="5879433"/>
              <a:chExt cx="864000" cy="75175"/>
            </a:xfrm>
          </p:grpSpPr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1D171E77-9B60-C043-8989-6A372B0D46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1EAC2B6C-E8EB-0A40-92FF-CD86D69816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id="{299D3AE4-E24E-A34B-B2ED-771AB0C8B8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0EB6F2FE-73A5-EA49-83F9-C4D0621FD45E}"/>
                </a:ext>
              </a:extLst>
            </p:cNvPr>
            <p:cNvGrpSpPr/>
            <p:nvPr/>
          </p:nvGrpSpPr>
          <p:grpSpPr>
            <a:xfrm>
              <a:off x="10719159" y="2683835"/>
              <a:ext cx="574962" cy="53469"/>
              <a:chOff x="2623154" y="5879433"/>
              <a:chExt cx="864000" cy="75175"/>
            </a:xfrm>
          </p:grpSpPr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E7284B78-191B-F84C-A092-719BD83B9C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942896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ABF9B37D-B4AC-8A47-88B8-BEFFF679F7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139D43F8-5340-5E4F-BA12-468A5FA290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E6AE24C7-5B1C-7C49-BE5E-E1F2A90A30D5}"/>
                </a:ext>
              </a:extLst>
            </p:cNvPr>
            <p:cNvSpPr/>
            <p:nvPr/>
          </p:nvSpPr>
          <p:spPr>
            <a:xfrm>
              <a:off x="6242197" y="224281"/>
              <a:ext cx="30489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6221BB8D-6710-5048-BAB0-5BED091FB262}"/>
                </a:ext>
              </a:extLst>
            </p:cNvPr>
            <p:cNvSpPr txBox="1"/>
            <p:nvPr/>
          </p:nvSpPr>
          <p:spPr>
            <a:xfrm>
              <a:off x="7089030" y="2533667"/>
              <a:ext cx="652743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8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8AA7D35C-F902-A942-9BEC-B4B6EB7A3571}"/>
                </a:ext>
              </a:extLst>
            </p:cNvPr>
            <p:cNvSpPr txBox="1"/>
            <p:nvPr/>
          </p:nvSpPr>
          <p:spPr>
            <a:xfrm>
              <a:off x="8922248" y="2613585"/>
              <a:ext cx="652743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7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B10D23CD-E015-E748-800C-99B1B58BA220}"/>
                </a:ext>
              </a:extLst>
            </p:cNvPr>
            <p:cNvSpPr txBox="1"/>
            <p:nvPr/>
          </p:nvSpPr>
          <p:spPr>
            <a:xfrm>
              <a:off x="10672671" y="2771115"/>
              <a:ext cx="652743" cy="2633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2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5975EA66-C98A-4E43-B743-6F989681C3A9}"/>
              </a:ext>
            </a:extLst>
          </p:cNvPr>
          <p:cNvGrpSpPr/>
          <p:nvPr/>
        </p:nvGrpSpPr>
        <p:grpSpPr>
          <a:xfrm>
            <a:off x="199663" y="3459089"/>
            <a:ext cx="5713463" cy="3142843"/>
            <a:chOff x="366008" y="3326937"/>
            <a:chExt cx="5713463" cy="3142843"/>
          </a:xfrm>
        </p:grpSpPr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CA8BE092-57DE-7E40-A539-83FEEC9B58B0}"/>
                </a:ext>
              </a:extLst>
            </p:cNvPr>
            <p:cNvSpPr/>
            <p:nvPr/>
          </p:nvSpPr>
          <p:spPr>
            <a:xfrm>
              <a:off x="408401" y="3605255"/>
              <a:ext cx="5648827" cy="2854942"/>
            </a:xfrm>
            <a:prstGeom prst="rect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229761B7-C7A4-D64A-B0E0-90DE195208AA}"/>
                </a:ext>
              </a:extLst>
            </p:cNvPr>
            <p:cNvSpPr txBox="1"/>
            <p:nvPr/>
          </p:nvSpPr>
          <p:spPr>
            <a:xfrm>
              <a:off x="487072" y="3740298"/>
              <a:ext cx="18838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mentary school children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420092F1-BBB8-FC41-BE77-EC1FE77D6379}"/>
                </a:ext>
              </a:extLst>
            </p:cNvPr>
            <p:cNvSpPr txBox="1"/>
            <p:nvPr/>
          </p:nvSpPr>
          <p:spPr>
            <a:xfrm>
              <a:off x="2269550" y="3739437"/>
              <a:ext cx="18662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unior high school students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2394AE00-DBE6-5E45-BAD1-84FA04288BF6}"/>
                </a:ext>
              </a:extLst>
            </p:cNvPr>
            <p:cNvSpPr txBox="1"/>
            <p:nvPr/>
          </p:nvSpPr>
          <p:spPr>
            <a:xfrm>
              <a:off x="4049748" y="3733352"/>
              <a:ext cx="20297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olescents and young adults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1A1DBF39-678E-724A-AFFF-D22759FB2187}"/>
                </a:ext>
              </a:extLst>
            </p:cNvPr>
            <p:cNvSpPr txBox="1"/>
            <p:nvPr/>
          </p:nvSpPr>
          <p:spPr>
            <a:xfrm>
              <a:off x="894712" y="6195382"/>
              <a:ext cx="1356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12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EEB24946-F4F9-A94D-8B68-2EE5B366423A}"/>
                </a:ext>
              </a:extLst>
            </p:cNvPr>
            <p:cNvSpPr txBox="1"/>
            <p:nvPr/>
          </p:nvSpPr>
          <p:spPr>
            <a:xfrm>
              <a:off x="2663532" y="6194268"/>
              <a:ext cx="1356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12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B6C4B438-44E3-DD44-9F67-D2354B917C70}"/>
                </a:ext>
              </a:extLst>
            </p:cNvPr>
            <p:cNvSpPr txBox="1"/>
            <p:nvPr/>
          </p:nvSpPr>
          <p:spPr>
            <a:xfrm>
              <a:off x="4499601" y="6208170"/>
              <a:ext cx="1356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12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44D00B35-9477-0F48-A555-B7FAE744368C}"/>
                </a:ext>
              </a:extLst>
            </p:cNvPr>
            <p:cNvSpPr txBox="1"/>
            <p:nvPr/>
          </p:nvSpPr>
          <p:spPr>
            <a:xfrm>
              <a:off x="1278981" y="3971874"/>
              <a:ext cx="379851" cy="187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9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08FBE03A-1616-A942-A361-9EF3C2133328}"/>
                </a:ext>
              </a:extLst>
            </p:cNvPr>
            <p:cNvSpPr txBox="1"/>
            <p:nvPr/>
          </p:nvSpPr>
          <p:spPr>
            <a:xfrm>
              <a:off x="3012732" y="3957056"/>
              <a:ext cx="379851" cy="187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9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F7E4828A-2C3C-AE40-84C1-95E0EC0837EF}"/>
                </a:ext>
              </a:extLst>
            </p:cNvPr>
            <p:cNvSpPr txBox="1"/>
            <p:nvPr/>
          </p:nvSpPr>
          <p:spPr>
            <a:xfrm>
              <a:off x="4866389" y="3944459"/>
              <a:ext cx="426905" cy="187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31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77" name="グラフ 76">
              <a:extLst>
                <a:ext uri="{FF2B5EF4-FFF2-40B4-BE49-F238E27FC236}">
                  <a16:creationId xmlns:a16="http://schemas.microsoft.com/office/drawing/2014/main" id="{95BD7B47-7679-E74A-8142-2A9A1745B6A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04980665"/>
                </p:ext>
              </p:extLst>
            </p:nvPr>
          </p:nvGraphicFramePr>
          <p:xfrm>
            <a:off x="4245892" y="4190027"/>
            <a:ext cx="1621175" cy="2065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78" name="グラフ 77">
              <a:extLst>
                <a:ext uri="{FF2B5EF4-FFF2-40B4-BE49-F238E27FC236}">
                  <a16:creationId xmlns:a16="http://schemas.microsoft.com/office/drawing/2014/main" id="{57D3AEFC-53E9-D94A-B1AF-65B409992CC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73089339"/>
                </p:ext>
              </p:extLst>
            </p:nvPr>
          </p:nvGraphicFramePr>
          <p:xfrm>
            <a:off x="2357833" y="4190027"/>
            <a:ext cx="1656491" cy="2065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79" name="グラフ 78">
              <a:extLst>
                <a:ext uri="{FF2B5EF4-FFF2-40B4-BE49-F238E27FC236}">
                  <a16:creationId xmlns:a16="http://schemas.microsoft.com/office/drawing/2014/main" id="{3081FE50-3F96-5D4C-ACC3-A0A01EDFAAE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96967"/>
                </p:ext>
              </p:extLst>
            </p:nvPr>
          </p:nvGraphicFramePr>
          <p:xfrm>
            <a:off x="571190" y="4190027"/>
            <a:ext cx="1549069" cy="2065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pSp>
          <p:nvGrpSpPr>
            <p:cNvPr id="80" name="グループ化 79">
              <a:extLst>
                <a:ext uri="{FF2B5EF4-FFF2-40B4-BE49-F238E27FC236}">
                  <a16:creationId xmlns:a16="http://schemas.microsoft.com/office/drawing/2014/main" id="{502EC27D-45A4-D642-9651-2292615DF9E4}"/>
                </a:ext>
              </a:extLst>
            </p:cNvPr>
            <p:cNvGrpSpPr/>
            <p:nvPr/>
          </p:nvGrpSpPr>
          <p:grpSpPr>
            <a:xfrm>
              <a:off x="1180710" y="5561431"/>
              <a:ext cx="576395" cy="53915"/>
              <a:chOff x="2616729" y="5879433"/>
              <a:chExt cx="864000" cy="75175"/>
            </a:xfrm>
          </p:grpSpPr>
          <p:cxnSp>
            <p:nvCxnSpPr>
              <p:cNvPr id="93" name="直線コネクタ 92">
                <a:extLst>
                  <a:ext uri="{FF2B5EF4-FFF2-40B4-BE49-F238E27FC236}">
                    <a16:creationId xmlns:a16="http://schemas.microsoft.com/office/drawing/2014/main" id="{E77B72E8-C3E7-6F48-998D-6EE7E4CEBA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線コネクタ 93">
                <a:extLst>
                  <a:ext uri="{FF2B5EF4-FFF2-40B4-BE49-F238E27FC236}">
                    <a16:creationId xmlns:a16="http://schemas.microsoft.com/office/drawing/2014/main" id="{226B2DDF-1109-FD4C-96D2-198F1FF30D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直線コネクタ 94">
                <a:extLst>
                  <a:ext uri="{FF2B5EF4-FFF2-40B4-BE49-F238E27FC236}">
                    <a16:creationId xmlns:a16="http://schemas.microsoft.com/office/drawing/2014/main" id="{03139AF1-F1FF-B548-AB9F-9A95BFBAE9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グループ化 80">
              <a:extLst>
                <a:ext uri="{FF2B5EF4-FFF2-40B4-BE49-F238E27FC236}">
                  <a16:creationId xmlns:a16="http://schemas.microsoft.com/office/drawing/2014/main" id="{A0CEF838-FAF9-374F-9426-BBBCEB39E7F5}"/>
                </a:ext>
              </a:extLst>
            </p:cNvPr>
            <p:cNvGrpSpPr/>
            <p:nvPr/>
          </p:nvGrpSpPr>
          <p:grpSpPr>
            <a:xfrm>
              <a:off x="3071735" y="5561431"/>
              <a:ext cx="587892" cy="49361"/>
              <a:chOff x="2616729" y="5879433"/>
              <a:chExt cx="864000" cy="75175"/>
            </a:xfrm>
          </p:grpSpPr>
          <p:cxnSp>
            <p:nvCxnSpPr>
              <p:cNvPr id="90" name="直線コネクタ 89">
                <a:extLst>
                  <a:ext uri="{FF2B5EF4-FFF2-40B4-BE49-F238E27FC236}">
                    <a16:creationId xmlns:a16="http://schemas.microsoft.com/office/drawing/2014/main" id="{45603DCA-E061-EB44-BFF5-8AB417BE05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線コネクタ 90">
                <a:extLst>
                  <a:ext uri="{FF2B5EF4-FFF2-40B4-BE49-F238E27FC236}">
                    <a16:creationId xmlns:a16="http://schemas.microsoft.com/office/drawing/2014/main" id="{A3739281-0486-4742-AFC4-193477DAB7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線コネクタ 91">
                <a:extLst>
                  <a:ext uri="{FF2B5EF4-FFF2-40B4-BE49-F238E27FC236}">
                    <a16:creationId xmlns:a16="http://schemas.microsoft.com/office/drawing/2014/main" id="{7D445AC2-0B1D-3F4E-8C4A-55B9EFE784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グループ化 81">
              <a:extLst>
                <a:ext uri="{FF2B5EF4-FFF2-40B4-BE49-F238E27FC236}">
                  <a16:creationId xmlns:a16="http://schemas.microsoft.com/office/drawing/2014/main" id="{CD735545-FA3E-584F-8971-16243F6BBF21}"/>
                </a:ext>
              </a:extLst>
            </p:cNvPr>
            <p:cNvGrpSpPr/>
            <p:nvPr/>
          </p:nvGrpSpPr>
          <p:grpSpPr>
            <a:xfrm>
              <a:off x="4889635" y="5913131"/>
              <a:ext cx="576395" cy="53915"/>
              <a:chOff x="2616729" y="5879433"/>
              <a:chExt cx="864000" cy="75175"/>
            </a:xfrm>
          </p:grpSpPr>
          <p:cxnSp>
            <p:nvCxnSpPr>
              <p:cNvPr id="87" name="直線コネクタ 86">
                <a:extLst>
                  <a:ext uri="{FF2B5EF4-FFF2-40B4-BE49-F238E27FC236}">
                    <a16:creationId xmlns:a16="http://schemas.microsoft.com/office/drawing/2014/main" id="{0F70A9DA-B7CA-EE4E-9F2A-A695845D03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線コネクタ 87">
                <a:extLst>
                  <a:ext uri="{FF2B5EF4-FFF2-40B4-BE49-F238E27FC236}">
                    <a16:creationId xmlns:a16="http://schemas.microsoft.com/office/drawing/2014/main" id="{862A2A09-5F65-9442-BA55-A36B6A6428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直線コネクタ 88">
                <a:extLst>
                  <a:ext uri="{FF2B5EF4-FFF2-40B4-BE49-F238E27FC236}">
                    <a16:creationId xmlns:a16="http://schemas.microsoft.com/office/drawing/2014/main" id="{0DDEB227-5B08-C44A-A097-C062116996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962DEFE2-D726-044F-9F4C-DDEA6882B7C2}"/>
                </a:ext>
              </a:extLst>
            </p:cNvPr>
            <p:cNvSpPr/>
            <p:nvPr/>
          </p:nvSpPr>
          <p:spPr>
            <a:xfrm>
              <a:off x="366008" y="3326937"/>
              <a:ext cx="34977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</a:t>
              </a:r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AA526492-3603-944F-8990-9B0FE7F33C0F}"/>
                </a:ext>
              </a:extLst>
            </p:cNvPr>
            <p:cNvSpPr txBox="1"/>
            <p:nvPr/>
          </p:nvSpPr>
          <p:spPr>
            <a:xfrm>
              <a:off x="1170383" y="5694270"/>
              <a:ext cx="435460" cy="187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8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05995A10-DCB2-1041-844B-7B4B121DCA1C}"/>
                </a:ext>
              </a:extLst>
            </p:cNvPr>
            <p:cNvSpPr txBox="1"/>
            <p:nvPr/>
          </p:nvSpPr>
          <p:spPr>
            <a:xfrm>
              <a:off x="3031035" y="5699100"/>
              <a:ext cx="435460" cy="187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7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4F65D66B-9CD5-1E42-AD81-582D5AD65716}"/>
                </a:ext>
              </a:extLst>
            </p:cNvPr>
            <p:cNvSpPr txBox="1"/>
            <p:nvPr/>
          </p:nvSpPr>
          <p:spPr>
            <a:xfrm>
              <a:off x="4873639" y="5981658"/>
              <a:ext cx="435460" cy="1876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1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99A43478-A502-6B49-A93D-E6A545CA4BD5}"/>
              </a:ext>
            </a:extLst>
          </p:cNvPr>
          <p:cNvSpPr/>
          <p:nvPr/>
        </p:nvSpPr>
        <p:spPr>
          <a:xfrm>
            <a:off x="6085472" y="3987432"/>
            <a:ext cx="6096000" cy="227517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 of health management awareness from baseline</a:t>
            </a:r>
            <a:endParaRPr lang="ja-JP" altLang="ja-JP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, comparison between baseline and 1-month; B, comparison between baseline and 6-month; C, comparison between baseline and 12-month. </a:t>
            </a:r>
          </a:p>
          <a:p>
            <a:pPr>
              <a:lnSpc>
                <a:spcPct val="150000"/>
              </a:lnSpc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cale for elementary school and junior high school children contained 7 and 9 questions with a 4-point numerical rating scale. The scale for adolescents and young adults was composed of 8 questions with a 5-point numerical rating scale. The result was expressed as the total score of all answers. The scores were compared between the baseline assessment and each of post-intervention assessments with the Wilcoxon signed-rank test.</a:t>
            </a:r>
            <a:r>
              <a:rPr lang="ja-JP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920627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78FD2C7E-3AAE-1546-AC74-0A317085B02F}"/>
              </a:ext>
            </a:extLst>
          </p:cNvPr>
          <p:cNvGrpSpPr/>
          <p:nvPr/>
        </p:nvGrpSpPr>
        <p:grpSpPr>
          <a:xfrm>
            <a:off x="832851" y="427286"/>
            <a:ext cx="4884740" cy="3048886"/>
            <a:chOff x="1021537" y="412772"/>
            <a:chExt cx="4884740" cy="3048886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44B68CC4-CE02-E047-A8D2-959244262F07}"/>
                </a:ext>
              </a:extLst>
            </p:cNvPr>
            <p:cNvSpPr/>
            <p:nvPr/>
          </p:nvSpPr>
          <p:spPr>
            <a:xfrm>
              <a:off x="1044323" y="673434"/>
              <a:ext cx="4861954" cy="2788224"/>
            </a:xfrm>
            <a:prstGeom prst="rect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A269A2A-F712-EE4C-8A25-029FA0886BD3}"/>
                </a:ext>
              </a:extLst>
            </p:cNvPr>
            <p:cNvSpPr txBox="1"/>
            <p:nvPr/>
          </p:nvSpPr>
          <p:spPr>
            <a:xfrm>
              <a:off x="1875576" y="773151"/>
              <a:ext cx="11176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hool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ildren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4D35130E-09B4-9F44-B9E5-09C75D552670}"/>
                </a:ext>
              </a:extLst>
            </p:cNvPr>
            <p:cNvSpPr txBox="1"/>
            <p:nvPr/>
          </p:nvSpPr>
          <p:spPr>
            <a:xfrm>
              <a:off x="3525668" y="753976"/>
              <a:ext cx="19014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olescents and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oung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dults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19EEB919-F7CA-8A45-9B48-CEC6998B89A4}"/>
                </a:ext>
              </a:extLst>
            </p:cNvPr>
            <p:cNvSpPr txBox="1"/>
            <p:nvPr/>
          </p:nvSpPr>
          <p:spPr>
            <a:xfrm>
              <a:off x="1712325" y="3046897"/>
              <a:ext cx="857662" cy="161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  1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B2BA79E-3EEC-844F-8E41-EC887229E55A}"/>
                </a:ext>
              </a:extLst>
            </p:cNvPr>
            <p:cNvSpPr txBox="1"/>
            <p:nvPr/>
          </p:nvSpPr>
          <p:spPr>
            <a:xfrm>
              <a:off x="3837596" y="3032615"/>
              <a:ext cx="857662" cy="161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  1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134655D2-DB8F-214D-9130-3A08B4D2785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88270162"/>
                </p:ext>
              </p:extLst>
            </p:nvPr>
          </p:nvGraphicFramePr>
          <p:xfrm>
            <a:off x="1380931" y="1176896"/>
            <a:ext cx="1920028" cy="17783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2" name="グラフ 11">
              <a:extLst>
                <a:ext uri="{FF2B5EF4-FFF2-40B4-BE49-F238E27FC236}">
                  <a16:creationId xmlns:a16="http://schemas.microsoft.com/office/drawing/2014/main" id="{DA10F086-BFCB-AB4F-934E-FDE3CAFFEE3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7891616"/>
                </p:ext>
              </p:extLst>
            </p:nvPr>
          </p:nvGraphicFramePr>
          <p:xfrm>
            <a:off x="3485589" y="1176896"/>
            <a:ext cx="2055240" cy="17783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9647287-340C-4646-A397-B78E99D8C4E5}"/>
                </a:ext>
              </a:extLst>
            </p:cNvPr>
            <p:cNvSpPr txBox="1"/>
            <p:nvPr/>
          </p:nvSpPr>
          <p:spPr>
            <a:xfrm>
              <a:off x="2204483" y="966059"/>
              <a:ext cx="366494" cy="161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21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07CDC627-4750-6C42-B9E4-758BEF99DF98}"/>
                </a:ext>
              </a:extLst>
            </p:cNvPr>
            <p:cNvSpPr txBox="1"/>
            <p:nvPr/>
          </p:nvSpPr>
          <p:spPr>
            <a:xfrm>
              <a:off x="4229829" y="990189"/>
              <a:ext cx="366494" cy="161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42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E6B5A1A3-A393-B842-BFEC-4F87520470EE}"/>
                </a:ext>
              </a:extLst>
            </p:cNvPr>
            <p:cNvGrpSpPr/>
            <p:nvPr/>
          </p:nvGrpSpPr>
          <p:grpSpPr>
            <a:xfrm>
              <a:off x="4229829" y="2555436"/>
              <a:ext cx="810257" cy="58540"/>
              <a:chOff x="2616729" y="5879433"/>
              <a:chExt cx="864000" cy="75175"/>
            </a:xfrm>
          </p:grpSpPr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32242819-0876-0046-906A-05789C45E5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線コネクタ 23">
                <a:extLst>
                  <a:ext uri="{FF2B5EF4-FFF2-40B4-BE49-F238E27FC236}">
                    <a16:creationId xmlns:a16="http://schemas.microsoft.com/office/drawing/2014/main" id="{5918C9E3-BD83-F442-BB76-F801374ECB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4638131D-293C-5D48-B4CD-2798FA1075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49AC226B-A00D-7245-BEBE-BC1DDE045FBB}"/>
                </a:ext>
              </a:extLst>
            </p:cNvPr>
            <p:cNvGrpSpPr/>
            <p:nvPr/>
          </p:nvGrpSpPr>
          <p:grpSpPr>
            <a:xfrm>
              <a:off x="2093530" y="2463751"/>
              <a:ext cx="714984" cy="91685"/>
              <a:chOff x="2616729" y="5879433"/>
              <a:chExt cx="864000" cy="75175"/>
            </a:xfrm>
          </p:grpSpPr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8021F463-772B-D44F-B025-942B6EA145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id="{D8B91363-50F3-F940-927E-AC9A38C362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id="{D30B4E6E-22D1-F340-AA12-65D52D5F884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70E8B2F7-FEA6-E246-BF55-3696F4DB1F04}"/>
                </a:ext>
              </a:extLst>
            </p:cNvPr>
            <p:cNvSpPr/>
            <p:nvPr/>
          </p:nvSpPr>
          <p:spPr>
            <a:xfrm>
              <a:off x="1021537" y="412772"/>
              <a:ext cx="31451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55A982BA-9089-2849-B3E5-6A186411852A}"/>
                </a:ext>
              </a:extLst>
            </p:cNvPr>
            <p:cNvSpPr txBox="1"/>
            <p:nvPr/>
          </p:nvSpPr>
          <p:spPr>
            <a:xfrm>
              <a:off x="2137358" y="2613976"/>
              <a:ext cx="373839" cy="161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3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DFCFB42-EE34-3F4C-8745-75E44E3EC31A}"/>
                </a:ext>
              </a:extLst>
            </p:cNvPr>
            <p:cNvSpPr txBox="1"/>
            <p:nvPr/>
          </p:nvSpPr>
          <p:spPr>
            <a:xfrm>
              <a:off x="4316011" y="2667571"/>
              <a:ext cx="7584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04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ADB86328-39C5-C648-82DA-4D04B09C04E7}"/>
              </a:ext>
            </a:extLst>
          </p:cNvPr>
          <p:cNvGrpSpPr/>
          <p:nvPr/>
        </p:nvGrpSpPr>
        <p:grpSpPr>
          <a:xfrm>
            <a:off x="6297779" y="448998"/>
            <a:ext cx="4889548" cy="3066494"/>
            <a:chOff x="1713204" y="828000"/>
            <a:chExt cx="8551973" cy="4913098"/>
          </a:xfrm>
        </p:grpSpPr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73941BE3-EDED-FB4F-AF4B-34F9CCB24F78}"/>
                </a:ext>
              </a:extLst>
            </p:cNvPr>
            <p:cNvSpPr/>
            <p:nvPr/>
          </p:nvSpPr>
          <p:spPr>
            <a:xfrm>
              <a:off x="1775933" y="1225543"/>
              <a:ext cx="8489244" cy="4515555"/>
            </a:xfrm>
            <a:prstGeom prst="rect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948D51C3-5AFC-584A-A1B3-C79D22C80802}"/>
                </a:ext>
              </a:extLst>
            </p:cNvPr>
            <p:cNvSpPr txBox="1"/>
            <p:nvPr/>
          </p:nvSpPr>
          <p:spPr>
            <a:xfrm>
              <a:off x="3089174" y="4900097"/>
              <a:ext cx="2495857" cy="419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6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4B61AE3C-F212-614A-8EDD-5701E2EB0AC2}"/>
                </a:ext>
              </a:extLst>
            </p:cNvPr>
            <p:cNvSpPr txBox="1"/>
            <p:nvPr/>
          </p:nvSpPr>
          <p:spPr>
            <a:xfrm>
              <a:off x="6731988" y="4952479"/>
              <a:ext cx="2495857" cy="419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6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184F33D7-35AA-2247-AAB2-027E7E15C8B4}"/>
                </a:ext>
              </a:extLst>
            </p:cNvPr>
            <p:cNvSpPr txBox="1"/>
            <p:nvPr/>
          </p:nvSpPr>
          <p:spPr>
            <a:xfrm>
              <a:off x="3590735" y="1712148"/>
              <a:ext cx="1119238" cy="419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8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E0A0FED2-E0A3-804A-878D-6A923C3953C7}"/>
                </a:ext>
              </a:extLst>
            </p:cNvPr>
            <p:cNvSpPr txBox="1"/>
            <p:nvPr/>
          </p:nvSpPr>
          <p:spPr>
            <a:xfrm>
              <a:off x="7179642" y="1712148"/>
              <a:ext cx="1119238" cy="419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38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32" name="グラフ 31">
              <a:extLst>
                <a:ext uri="{FF2B5EF4-FFF2-40B4-BE49-F238E27FC236}">
                  <a16:creationId xmlns:a16="http://schemas.microsoft.com/office/drawing/2014/main" id="{314A75C9-0448-2642-A53C-BCFFAA3839A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16193783"/>
                </p:ext>
              </p:extLst>
            </p:nvPr>
          </p:nvGraphicFramePr>
          <p:xfrm>
            <a:off x="6073730" y="2034678"/>
            <a:ext cx="3552267" cy="28800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F9DBF130-1004-104F-B2BC-F94A6D25D38C}"/>
                </a:ext>
              </a:extLst>
            </p:cNvPr>
            <p:cNvSpPr txBox="1"/>
            <p:nvPr/>
          </p:nvSpPr>
          <p:spPr>
            <a:xfrm>
              <a:off x="3215354" y="1420537"/>
              <a:ext cx="1937920" cy="4438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hool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ildren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5E55D36E-3F2E-914C-B129-DC706B046834}"/>
                </a:ext>
              </a:extLst>
            </p:cNvPr>
            <p:cNvSpPr txBox="1"/>
            <p:nvPr/>
          </p:nvSpPr>
          <p:spPr>
            <a:xfrm>
              <a:off x="6229514" y="1400893"/>
              <a:ext cx="3384629" cy="4438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olescents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young adults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35" name="グラフ 34">
              <a:extLst>
                <a:ext uri="{FF2B5EF4-FFF2-40B4-BE49-F238E27FC236}">
                  <a16:creationId xmlns:a16="http://schemas.microsoft.com/office/drawing/2014/main" id="{31444BD1-5332-E646-B712-8CBCCC74383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4523350"/>
                </p:ext>
              </p:extLst>
            </p:nvPr>
          </p:nvGraphicFramePr>
          <p:xfrm>
            <a:off x="2324973" y="2034678"/>
            <a:ext cx="3383421" cy="28800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C51DB5E6-EAE6-AE4A-B4BD-A7A876C30368}"/>
                </a:ext>
              </a:extLst>
            </p:cNvPr>
            <p:cNvSpPr/>
            <p:nvPr/>
          </p:nvSpPr>
          <p:spPr>
            <a:xfrm>
              <a:off x="1713204" y="828000"/>
              <a:ext cx="513638" cy="4931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C7A43F7E-E55F-3045-8270-25CBE1695A2A}"/>
              </a:ext>
            </a:extLst>
          </p:cNvPr>
          <p:cNvGrpSpPr/>
          <p:nvPr/>
        </p:nvGrpSpPr>
        <p:grpSpPr>
          <a:xfrm>
            <a:off x="818433" y="3551233"/>
            <a:ext cx="4899158" cy="3078533"/>
            <a:chOff x="791669" y="3547285"/>
            <a:chExt cx="4899158" cy="3078533"/>
          </a:xfrm>
        </p:grpSpPr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4C7AA355-CC4B-504D-80BC-25B84411010F}"/>
                </a:ext>
              </a:extLst>
            </p:cNvPr>
            <p:cNvSpPr/>
            <p:nvPr/>
          </p:nvSpPr>
          <p:spPr>
            <a:xfrm>
              <a:off x="801378" y="3831259"/>
              <a:ext cx="4889449" cy="2794559"/>
            </a:xfrm>
            <a:prstGeom prst="rect">
              <a:avLst/>
            </a:prstGeom>
            <a:noFill/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D424EA1C-328B-F44A-A8E4-8D3ACB0308D7}"/>
                </a:ext>
              </a:extLst>
            </p:cNvPr>
            <p:cNvSpPr txBox="1"/>
            <p:nvPr/>
          </p:nvSpPr>
          <p:spPr>
            <a:xfrm>
              <a:off x="1473822" y="6242675"/>
              <a:ext cx="15327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12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F8FF770F-522A-C040-8651-E0F740BB1179}"/>
                </a:ext>
              </a:extLst>
            </p:cNvPr>
            <p:cNvSpPr txBox="1"/>
            <p:nvPr/>
          </p:nvSpPr>
          <p:spPr>
            <a:xfrm>
              <a:off x="3624957" y="6242675"/>
              <a:ext cx="15327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       12-month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41" name="グラフ 40">
              <a:extLst>
                <a:ext uri="{FF2B5EF4-FFF2-40B4-BE49-F238E27FC236}">
                  <a16:creationId xmlns:a16="http://schemas.microsoft.com/office/drawing/2014/main" id="{B2B63014-1F3D-F74F-865A-4017C5F443B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1894614"/>
                </p:ext>
              </p:extLst>
            </p:nvPr>
          </p:nvGraphicFramePr>
          <p:xfrm>
            <a:off x="1141445" y="4335865"/>
            <a:ext cx="1969954" cy="17823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2F3E7842-BB81-9E4F-A16F-D155C25521E2}"/>
                </a:ext>
              </a:extLst>
            </p:cNvPr>
            <p:cNvSpPr txBox="1"/>
            <p:nvPr/>
          </p:nvSpPr>
          <p:spPr>
            <a:xfrm>
              <a:off x="1976051" y="4157237"/>
              <a:ext cx="368567" cy="1619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18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CC786463-F985-0A49-8E2F-A36FB5BB2E48}"/>
                </a:ext>
              </a:extLst>
            </p:cNvPr>
            <p:cNvSpPr txBox="1"/>
            <p:nvPr/>
          </p:nvSpPr>
          <p:spPr>
            <a:xfrm>
              <a:off x="3912025" y="4146998"/>
              <a:ext cx="6872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31)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48B97181-0F4E-B546-BED4-CE6D49027D49}"/>
                </a:ext>
              </a:extLst>
            </p:cNvPr>
            <p:cNvSpPr txBox="1"/>
            <p:nvPr/>
          </p:nvSpPr>
          <p:spPr>
            <a:xfrm>
              <a:off x="1699288" y="3953772"/>
              <a:ext cx="11576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hool children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90C55C28-26D3-934F-99CC-1D388FD799F4}"/>
                </a:ext>
              </a:extLst>
            </p:cNvPr>
            <p:cNvSpPr txBox="1"/>
            <p:nvPr/>
          </p:nvSpPr>
          <p:spPr>
            <a:xfrm>
              <a:off x="3399681" y="3928733"/>
              <a:ext cx="20297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olescents and young adults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46" name="グラフ 45">
              <a:extLst>
                <a:ext uri="{FF2B5EF4-FFF2-40B4-BE49-F238E27FC236}">
                  <a16:creationId xmlns:a16="http://schemas.microsoft.com/office/drawing/2014/main" id="{F65FDD1F-EE54-9343-8266-BFAEFAD45A4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13346020"/>
                </p:ext>
              </p:extLst>
            </p:nvPr>
          </p:nvGraphicFramePr>
          <p:xfrm>
            <a:off x="3286181" y="4335471"/>
            <a:ext cx="1938961" cy="17823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D969442C-9DE9-C648-9BE9-50379D5D15FA}"/>
                </a:ext>
              </a:extLst>
            </p:cNvPr>
            <p:cNvGrpSpPr/>
            <p:nvPr/>
          </p:nvGrpSpPr>
          <p:grpSpPr>
            <a:xfrm>
              <a:off x="3912025" y="5796523"/>
              <a:ext cx="801489" cy="49664"/>
              <a:chOff x="2616729" y="5879433"/>
              <a:chExt cx="864000" cy="75175"/>
            </a:xfrm>
          </p:grpSpPr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807D40DC-CE39-A744-B34F-862A967FB8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6729" y="5948258"/>
                <a:ext cx="86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C6DD9046-0D5A-B04C-BEF4-66385B8E75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23154" y="587943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3A8FDA67-F6E5-174E-8E7E-3A929454F9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5419" y="5882608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6A70DAF0-8DE9-0C49-B440-F95368FF284A}"/>
                </a:ext>
              </a:extLst>
            </p:cNvPr>
            <p:cNvSpPr/>
            <p:nvPr/>
          </p:nvSpPr>
          <p:spPr>
            <a:xfrm>
              <a:off x="791669" y="3547285"/>
              <a:ext cx="28405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ja-JP" alt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4E8ECB75-53AD-3D4F-AE83-C00FA74A6EB8}"/>
                </a:ext>
              </a:extLst>
            </p:cNvPr>
            <p:cNvSpPr txBox="1"/>
            <p:nvPr/>
          </p:nvSpPr>
          <p:spPr>
            <a:xfrm>
              <a:off x="4025159" y="5908716"/>
              <a:ext cx="375953" cy="1619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0.021</a:t>
              </a:r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3390DAE6-9EFE-CF4F-BF78-F39A53D960DC}"/>
              </a:ext>
            </a:extLst>
          </p:cNvPr>
          <p:cNvSpPr/>
          <p:nvPr/>
        </p:nvSpPr>
        <p:spPr>
          <a:xfrm>
            <a:off x="5985139" y="3859010"/>
            <a:ext cx="6096000" cy="227517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 of self-esteem awareness from baseline</a:t>
            </a:r>
            <a:endParaRPr lang="ja-JP" altLang="ja-JP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, comparison between baseline and 1-month; E, comparison between baseline and 6-month; F, comparison between baseline and 12-month. 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The scale for school children contained 10 questions with a 4-point </a:t>
            </a:r>
            <a:r>
              <a:rPr lang="en-US" altLang="ja-JP" sz="1200" spc="-3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numerical rating scale. The scale for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adolescents and young adults was composed of 10 questions with a 4-point </a:t>
            </a:r>
            <a:r>
              <a:rPr lang="en-US" altLang="ja-JP" sz="1200" spc="-3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numerical rating scale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. The result was expressed as the total score of all answers. </a:t>
            </a:r>
            <a:r>
              <a:rPr lang="en-US" altLang="ja-JP" sz="1200" spc="-3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The scores were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ompared between the baseline assessment and each of post-intervention assessments with the Wilcoxon signed-rank test. </a:t>
            </a:r>
            <a:endParaRPr lang="ja-JP" altLang="ja-JP" sz="12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39614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2" name="グラフ 131">
            <a:extLst>
              <a:ext uri="{FF2B5EF4-FFF2-40B4-BE49-F238E27FC236}">
                <a16:creationId xmlns:a16="http://schemas.microsoft.com/office/drawing/2014/main" id="{6DB89B62-D12F-C649-B451-2CDE78AE23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6753249"/>
              </p:ext>
            </p:extLst>
          </p:nvPr>
        </p:nvGraphicFramePr>
        <p:xfrm>
          <a:off x="8290355" y="1047018"/>
          <a:ext cx="2040195" cy="17633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3" name="グラフ 132">
            <a:extLst>
              <a:ext uri="{FF2B5EF4-FFF2-40B4-BE49-F238E27FC236}">
                <a16:creationId xmlns:a16="http://schemas.microsoft.com/office/drawing/2014/main" id="{3B1D9A87-044E-EE41-8CF9-19684C6E57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092143"/>
              </p:ext>
            </p:extLst>
          </p:nvPr>
        </p:nvGraphicFramePr>
        <p:xfrm>
          <a:off x="6257491" y="1027544"/>
          <a:ext cx="1754264" cy="17840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4" name="グラフ 133">
            <a:extLst>
              <a:ext uri="{FF2B5EF4-FFF2-40B4-BE49-F238E27FC236}">
                <a16:creationId xmlns:a16="http://schemas.microsoft.com/office/drawing/2014/main" id="{4D4251DB-3668-6C47-B856-2E872F13BF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1900311"/>
              </p:ext>
            </p:extLst>
          </p:nvPr>
        </p:nvGraphicFramePr>
        <p:xfrm>
          <a:off x="716999" y="1026241"/>
          <a:ext cx="1882761" cy="17752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5" name="グラフ 134">
            <a:extLst>
              <a:ext uri="{FF2B5EF4-FFF2-40B4-BE49-F238E27FC236}">
                <a16:creationId xmlns:a16="http://schemas.microsoft.com/office/drawing/2014/main" id="{5F3D9B44-427F-7645-81F8-1DD8C3F9DD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0048705"/>
              </p:ext>
            </p:extLst>
          </p:nvPr>
        </p:nvGraphicFramePr>
        <p:xfrm>
          <a:off x="727926" y="4143361"/>
          <a:ext cx="1838753" cy="18263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6" name="正方形/長方形 135">
            <a:extLst>
              <a:ext uri="{FF2B5EF4-FFF2-40B4-BE49-F238E27FC236}">
                <a16:creationId xmlns:a16="http://schemas.microsoft.com/office/drawing/2014/main" id="{09444348-741A-A441-8CC9-DCE5F047A227}"/>
              </a:ext>
            </a:extLst>
          </p:cNvPr>
          <p:cNvSpPr/>
          <p:nvPr/>
        </p:nvSpPr>
        <p:spPr>
          <a:xfrm>
            <a:off x="434335" y="470336"/>
            <a:ext cx="4708042" cy="2641596"/>
          </a:xfrm>
          <a:prstGeom prst="rect">
            <a:avLst/>
          </a:prstGeom>
          <a:noFill/>
          <a:ln w="63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E432BF8E-DA69-614F-ACE3-BF5B40406BE3}"/>
              </a:ext>
            </a:extLst>
          </p:cNvPr>
          <p:cNvSpPr txBox="1"/>
          <p:nvPr/>
        </p:nvSpPr>
        <p:spPr>
          <a:xfrm>
            <a:off x="1098842" y="581895"/>
            <a:ext cx="1117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ool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ren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EE84CC6F-EA0A-6A45-A704-48C3E0D400E7}"/>
              </a:ext>
            </a:extLst>
          </p:cNvPr>
          <p:cNvSpPr txBox="1"/>
          <p:nvPr/>
        </p:nvSpPr>
        <p:spPr>
          <a:xfrm>
            <a:off x="2938175" y="575908"/>
            <a:ext cx="20297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lescents and young adults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DB594630-B7B7-094F-B74B-9EFB7CE8EB46}"/>
              </a:ext>
            </a:extLst>
          </p:cNvPr>
          <p:cNvSpPr txBox="1"/>
          <p:nvPr/>
        </p:nvSpPr>
        <p:spPr>
          <a:xfrm>
            <a:off x="1445302" y="759385"/>
            <a:ext cx="354892" cy="1530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21)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035FABB9-EFA6-414F-ADAC-49035B1F0101}"/>
              </a:ext>
            </a:extLst>
          </p:cNvPr>
          <p:cNvSpPr txBox="1"/>
          <p:nvPr/>
        </p:nvSpPr>
        <p:spPr>
          <a:xfrm>
            <a:off x="3654256" y="825817"/>
            <a:ext cx="354892" cy="1530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42)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9F39C9DC-B4F9-DF41-9E6B-CDA6C497D225}"/>
              </a:ext>
            </a:extLst>
          </p:cNvPr>
          <p:cNvSpPr txBox="1"/>
          <p:nvPr/>
        </p:nvSpPr>
        <p:spPr>
          <a:xfrm>
            <a:off x="961747" y="2799909"/>
            <a:ext cx="14622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       1-month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563B90CA-0B9B-6848-B5A1-81AAB92AE74F}"/>
              </a:ext>
            </a:extLst>
          </p:cNvPr>
          <p:cNvSpPr txBox="1"/>
          <p:nvPr/>
        </p:nvSpPr>
        <p:spPr>
          <a:xfrm>
            <a:off x="3168442" y="2799909"/>
            <a:ext cx="14622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        1-month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3" name="グループ化 142">
            <a:extLst>
              <a:ext uri="{FF2B5EF4-FFF2-40B4-BE49-F238E27FC236}">
                <a16:creationId xmlns:a16="http://schemas.microsoft.com/office/drawing/2014/main" id="{A35C8601-232F-754F-ACA5-9FE63A691C53}"/>
              </a:ext>
            </a:extLst>
          </p:cNvPr>
          <p:cNvGrpSpPr/>
          <p:nvPr/>
        </p:nvGrpSpPr>
        <p:grpSpPr>
          <a:xfrm>
            <a:off x="3510131" y="2393744"/>
            <a:ext cx="850814" cy="58342"/>
            <a:chOff x="2616729" y="5879433"/>
            <a:chExt cx="864000" cy="75175"/>
          </a:xfrm>
        </p:grpSpPr>
        <p:cxnSp>
          <p:nvCxnSpPr>
            <p:cNvPr id="144" name="直線コネクタ 143">
              <a:extLst>
                <a:ext uri="{FF2B5EF4-FFF2-40B4-BE49-F238E27FC236}">
                  <a16:creationId xmlns:a16="http://schemas.microsoft.com/office/drawing/2014/main" id="{852ABA40-1563-CD41-9783-2ACF05E8C782}"/>
                </a:ext>
              </a:extLst>
            </p:cNvPr>
            <p:cNvCxnSpPr>
              <a:cxnSpLocks/>
            </p:cNvCxnSpPr>
            <p:nvPr/>
          </p:nvCxnSpPr>
          <p:spPr>
            <a:xfrm>
              <a:off x="2616729" y="5948258"/>
              <a:ext cx="8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線コネクタ 144">
              <a:extLst>
                <a:ext uri="{FF2B5EF4-FFF2-40B4-BE49-F238E27FC236}">
                  <a16:creationId xmlns:a16="http://schemas.microsoft.com/office/drawing/2014/main" id="{37D36C39-747E-824C-B683-CE8063F17708}"/>
                </a:ext>
              </a:extLst>
            </p:cNvPr>
            <p:cNvCxnSpPr>
              <a:cxnSpLocks/>
            </p:cNvCxnSpPr>
            <p:nvPr/>
          </p:nvCxnSpPr>
          <p:spPr>
            <a:xfrm>
              <a:off x="2623154" y="5879433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885F48B9-7FFB-FD44-8C46-E82BC9EBAFD9}"/>
                </a:ext>
              </a:extLst>
            </p:cNvPr>
            <p:cNvCxnSpPr>
              <a:cxnSpLocks/>
            </p:cNvCxnSpPr>
            <p:nvPr/>
          </p:nvCxnSpPr>
          <p:spPr>
            <a:xfrm>
              <a:off x="3475419" y="5882608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7" name="グループ化 146">
            <a:extLst>
              <a:ext uri="{FF2B5EF4-FFF2-40B4-BE49-F238E27FC236}">
                <a16:creationId xmlns:a16="http://schemas.microsoft.com/office/drawing/2014/main" id="{41D43E18-590E-DE43-A8EB-25352AF419C6}"/>
              </a:ext>
            </a:extLst>
          </p:cNvPr>
          <p:cNvGrpSpPr/>
          <p:nvPr/>
        </p:nvGrpSpPr>
        <p:grpSpPr>
          <a:xfrm>
            <a:off x="1404391" y="2363391"/>
            <a:ext cx="725797" cy="67085"/>
            <a:chOff x="2616729" y="5879433"/>
            <a:chExt cx="864000" cy="75175"/>
          </a:xfrm>
        </p:grpSpPr>
        <p:cxnSp>
          <p:nvCxnSpPr>
            <p:cNvPr id="148" name="直線コネクタ 147">
              <a:extLst>
                <a:ext uri="{FF2B5EF4-FFF2-40B4-BE49-F238E27FC236}">
                  <a16:creationId xmlns:a16="http://schemas.microsoft.com/office/drawing/2014/main" id="{4DD22E65-6CA9-244E-8490-5B846B79D131}"/>
                </a:ext>
              </a:extLst>
            </p:cNvPr>
            <p:cNvCxnSpPr>
              <a:cxnSpLocks/>
            </p:cNvCxnSpPr>
            <p:nvPr/>
          </p:nvCxnSpPr>
          <p:spPr>
            <a:xfrm>
              <a:off x="2616729" y="5948258"/>
              <a:ext cx="8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5BA594A7-24FB-414A-8584-F6E13E28BEE8}"/>
                </a:ext>
              </a:extLst>
            </p:cNvPr>
            <p:cNvCxnSpPr>
              <a:cxnSpLocks/>
            </p:cNvCxnSpPr>
            <p:nvPr/>
          </p:nvCxnSpPr>
          <p:spPr>
            <a:xfrm>
              <a:off x="2623154" y="5879433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線コネクタ 149">
              <a:extLst>
                <a:ext uri="{FF2B5EF4-FFF2-40B4-BE49-F238E27FC236}">
                  <a16:creationId xmlns:a16="http://schemas.microsoft.com/office/drawing/2014/main" id="{19B0F958-DB44-314C-8405-9A4C0FAB96CC}"/>
                </a:ext>
              </a:extLst>
            </p:cNvPr>
            <p:cNvCxnSpPr>
              <a:cxnSpLocks/>
            </p:cNvCxnSpPr>
            <p:nvPr/>
          </p:nvCxnSpPr>
          <p:spPr>
            <a:xfrm>
              <a:off x="3475419" y="5882608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6A6D3D1E-A430-6149-A79B-01A55670E665}"/>
              </a:ext>
            </a:extLst>
          </p:cNvPr>
          <p:cNvSpPr/>
          <p:nvPr/>
        </p:nvSpPr>
        <p:spPr>
          <a:xfrm>
            <a:off x="1461329" y="2403062"/>
            <a:ext cx="381562" cy="15304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i="1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&lt;0.00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C3B4B3F4-FD05-1744-A9EE-C65F7DEAA244}"/>
              </a:ext>
            </a:extLst>
          </p:cNvPr>
          <p:cNvSpPr/>
          <p:nvPr/>
        </p:nvSpPr>
        <p:spPr>
          <a:xfrm>
            <a:off x="3633567" y="2413250"/>
            <a:ext cx="76800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i="1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&lt;0.00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正方形/長方形 152">
            <a:extLst>
              <a:ext uri="{FF2B5EF4-FFF2-40B4-BE49-F238E27FC236}">
                <a16:creationId xmlns:a16="http://schemas.microsoft.com/office/drawing/2014/main" id="{FAFDCC11-54CE-0543-BDD8-F6D483C835C2}"/>
              </a:ext>
            </a:extLst>
          </p:cNvPr>
          <p:cNvSpPr/>
          <p:nvPr/>
        </p:nvSpPr>
        <p:spPr>
          <a:xfrm>
            <a:off x="5973961" y="480755"/>
            <a:ext cx="4708042" cy="2641596"/>
          </a:xfrm>
          <a:prstGeom prst="rect">
            <a:avLst/>
          </a:prstGeom>
          <a:noFill/>
          <a:ln w="63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FEDD319B-47D7-BD45-B038-0D3928DA7AD7}"/>
              </a:ext>
            </a:extLst>
          </p:cNvPr>
          <p:cNvSpPr txBox="1"/>
          <p:nvPr/>
        </p:nvSpPr>
        <p:spPr>
          <a:xfrm>
            <a:off x="6656497" y="559847"/>
            <a:ext cx="11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ool children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5EA6CC9B-CE32-2349-9328-1960DE78DD59}"/>
              </a:ext>
            </a:extLst>
          </p:cNvPr>
          <p:cNvSpPr txBox="1"/>
          <p:nvPr/>
        </p:nvSpPr>
        <p:spPr>
          <a:xfrm>
            <a:off x="8418875" y="559846"/>
            <a:ext cx="19351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lescents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young adults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205CB5F9-B9DD-2D4B-BA68-60D2E9C28DAC}"/>
              </a:ext>
            </a:extLst>
          </p:cNvPr>
          <p:cNvSpPr txBox="1"/>
          <p:nvPr/>
        </p:nvSpPr>
        <p:spPr>
          <a:xfrm>
            <a:off x="6516531" y="2781081"/>
            <a:ext cx="1391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      6-month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241D6CE4-56CE-2741-9F8E-17A27DC6E61D}"/>
              </a:ext>
            </a:extLst>
          </p:cNvPr>
          <p:cNvSpPr txBox="1"/>
          <p:nvPr/>
        </p:nvSpPr>
        <p:spPr>
          <a:xfrm>
            <a:off x="8861631" y="2793523"/>
            <a:ext cx="13211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    6-month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A8249D8C-2DAB-A24C-B413-2DB9229EB22D}"/>
              </a:ext>
            </a:extLst>
          </p:cNvPr>
          <p:cNvSpPr txBox="1"/>
          <p:nvPr/>
        </p:nvSpPr>
        <p:spPr>
          <a:xfrm>
            <a:off x="6998263" y="725174"/>
            <a:ext cx="354892" cy="1664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18)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E9EBD482-365E-7F40-B5B0-3756D0ACFF96}"/>
              </a:ext>
            </a:extLst>
          </p:cNvPr>
          <p:cNvSpPr txBox="1"/>
          <p:nvPr/>
        </p:nvSpPr>
        <p:spPr>
          <a:xfrm>
            <a:off x="9010911" y="780933"/>
            <a:ext cx="7482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38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0" name="グループ化 159">
            <a:extLst>
              <a:ext uri="{FF2B5EF4-FFF2-40B4-BE49-F238E27FC236}">
                <a16:creationId xmlns:a16="http://schemas.microsoft.com/office/drawing/2014/main" id="{B2585587-80AA-AB4F-9471-2571979B1FD1}"/>
              </a:ext>
            </a:extLst>
          </p:cNvPr>
          <p:cNvGrpSpPr/>
          <p:nvPr/>
        </p:nvGrpSpPr>
        <p:grpSpPr>
          <a:xfrm>
            <a:off x="9039200" y="2343216"/>
            <a:ext cx="861579" cy="62858"/>
            <a:chOff x="2616729" y="5879433"/>
            <a:chExt cx="864000" cy="75175"/>
          </a:xfrm>
        </p:grpSpPr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2CE09103-8196-904A-A478-EFBCE5EE0DC5}"/>
                </a:ext>
              </a:extLst>
            </p:cNvPr>
            <p:cNvCxnSpPr>
              <a:cxnSpLocks/>
            </p:cNvCxnSpPr>
            <p:nvPr/>
          </p:nvCxnSpPr>
          <p:spPr>
            <a:xfrm>
              <a:off x="2616729" y="5948258"/>
              <a:ext cx="8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2D8A15C2-5FA9-614C-AB96-9D682AB8CD71}"/>
                </a:ext>
              </a:extLst>
            </p:cNvPr>
            <p:cNvCxnSpPr>
              <a:cxnSpLocks/>
            </p:cNvCxnSpPr>
            <p:nvPr/>
          </p:nvCxnSpPr>
          <p:spPr>
            <a:xfrm>
              <a:off x="2623154" y="5879433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線コネクタ 162">
              <a:extLst>
                <a:ext uri="{FF2B5EF4-FFF2-40B4-BE49-F238E27FC236}">
                  <a16:creationId xmlns:a16="http://schemas.microsoft.com/office/drawing/2014/main" id="{4E8F39DA-404B-AC48-A116-8DF27C052689}"/>
                </a:ext>
              </a:extLst>
            </p:cNvPr>
            <p:cNvCxnSpPr>
              <a:cxnSpLocks/>
            </p:cNvCxnSpPr>
            <p:nvPr/>
          </p:nvCxnSpPr>
          <p:spPr>
            <a:xfrm>
              <a:off x="3475419" y="5882608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4862A88E-FBE5-1F4E-916C-4BDAF9E1758C}"/>
              </a:ext>
            </a:extLst>
          </p:cNvPr>
          <p:cNvGrpSpPr/>
          <p:nvPr/>
        </p:nvGrpSpPr>
        <p:grpSpPr>
          <a:xfrm>
            <a:off x="6909375" y="2350811"/>
            <a:ext cx="698648" cy="64646"/>
            <a:chOff x="2616729" y="5879433"/>
            <a:chExt cx="864000" cy="75175"/>
          </a:xfrm>
        </p:grpSpPr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AD233AC4-02CB-B042-8F73-3F8E6F773FB3}"/>
                </a:ext>
              </a:extLst>
            </p:cNvPr>
            <p:cNvCxnSpPr>
              <a:cxnSpLocks/>
            </p:cNvCxnSpPr>
            <p:nvPr/>
          </p:nvCxnSpPr>
          <p:spPr>
            <a:xfrm>
              <a:off x="2616729" y="5948258"/>
              <a:ext cx="8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BBF2843E-2932-224A-A61A-B0F5488D8EFF}"/>
                </a:ext>
              </a:extLst>
            </p:cNvPr>
            <p:cNvCxnSpPr>
              <a:cxnSpLocks/>
            </p:cNvCxnSpPr>
            <p:nvPr/>
          </p:nvCxnSpPr>
          <p:spPr>
            <a:xfrm>
              <a:off x="2623154" y="5879433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コネクタ 166">
              <a:extLst>
                <a:ext uri="{FF2B5EF4-FFF2-40B4-BE49-F238E27FC236}">
                  <a16:creationId xmlns:a16="http://schemas.microsoft.com/office/drawing/2014/main" id="{9083DDBD-06D1-BB43-BC75-CEEBF0620ACB}"/>
                </a:ext>
              </a:extLst>
            </p:cNvPr>
            <p:cNvCxnSpPr>
              <a:cxnSpLocks/>
            </p:cNvCxnSpPr>
            <p:nvPr/>
          </p:nvCxnSpPr>
          <p:spPr>
            <a:xfrm>
              <a:off x="3475419" y="5882608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8" name="正方形/長方形 167">
            <a:extLst>
              <a:ext uri="{FF2B5EF4-FFF2-40B4-BE49-F238E27FC236}">
                <a16:creationId xmlns:a16="http://schemas.microsoft.com/office/drawing/2014/main" id="{784E47A8-7DBF-BC40-A47E-DFA2A636E45E}"/>
              </a:ext>
            </a:extLst>
          </p:cNvPr>
          <p:cNvSpPr/>
          <p:nvPr/>
        </p:nvSpPr>
        <p:spPr>
          <a:xfrm>
            <a:off x="6950662" y="2382028"/>
            <a:ext cx="381562" cy="1664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i="1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=0.00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正方形/長方形 168">
            <a:extLst>
              <a:ext uri="{FF2B5EF4-FFF2-40B4-BE49-F238E27FC236}">
                <a16:creationId xmlns:a16="http://schemas.microsoft.com/office/drawing/2014/main" id="{10863B30-96D9-1A49-B2D5-8557E59E3C58}"/>
              </a:ext>
            </a:extLst>
          </p:cNvPr>
          <p:cNvSpPr/>
          <p:nvPr/>
        </p:nvSpPr>
        <p:spPr>
          <a:xfrm>
            <a:off x="9162716" y="2410433"/>
            <a:ext cx="381562" cy="1664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i="1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&lt;0.00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正方形/長方形 169">
            <a:extLst>
              <a:ext uri="{FF2B5EF4-FFF2-40B4-BE49-F238E27FC236}">
                <a16:creationId xmlns:a16="http://schemas.microsoft.com/office/drawing/2014/main" id="{6217848E-ED3C-9B48-8598-E29DD6998897}"/>
              </a:ext>
            </a:extLst>
          </p:cNvPr>
          <p:cNvSpPr/>
          <p:nvPr/>
        </p:nvSpPr>
        <p:spPr>
          <a:xfrm>
            <a:off x="442504" y="3580175"/>
            <a:ext cx="4710758" cy="2598216"/>
          </a:xfrm>
          <a:prstGeom prst="rect">
            <a:avLst/>
          </a:prstGeom>
          <a:noFill/>
          <a:ln w="63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C3BDC147-454C-C240-B757-449760E5D522}"/>
              </a:ext>
            </a:extLst>
          </p:cNvPr>
          <p:cNvSpPr txBox="1"/>
          <p:nvPr/>
        </p:nvSpPr>
        <p:spPr>
          <a:xfrm>
            <a:off x="1171594" y="3671577"/>
            <a:ext cx="1117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ool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ren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B40924BA-599F-794C-9E4B-19DBD0C52610}"/>
              </a:ext>
            </a:extLst>
          </p:cNvPr>
          <p:cNvSpPr txBox="1"/>
          <p:nvPr/>
        </p:nvSpPr>
        <p:spPr>
          <a:xfrm>
            <a:off x="2864129" y="3669894"/>
            <a:ext cx="19351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lescents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young adults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30BB9B38-2F94-A840-A6DD-B44AED400D6B}"/>
              </a:ext>
            </a:extLst>
          </p:cNvPr>
          <p:cNvSpPr txBox="1"/>
          <p:nvPr/>
        </p:nvSpPr>
        <p:spPr>
          <a:xfrm>
            <a:off x="1052581" y="5892593"/>
            <a:ext cx="830991" cy="1505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       12-month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89300FCC-F480-8C48-BD31-8906BDD4FE16}"/>
              </a:ext>
            </a:extLst>
          </p:cNvPr>
          <p:cNvSpPr txBox="1"/>
          <p:nvPr/>
        </p:nvSpPr>
        <p:spPr>
          <a:xfrm>
            <a:off x="3189042" y="5892593"/>
            <a:ext cx="830991" cy="1505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       12-month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30533A66-E0AB-E04A-B3C4-E83EBCC3A26E}"/>
              </a:ext>
            </a:extLst>
          </p:cNvPr>
          <p:cNvSpPr txBox="1"/>
          <p:nvPr/>
        </p:nvSpPr>
        <p:spPr>
          <a:xfrm>
            <a:off x="1528475" y="3871629"/>
            <a:ext cx="355097" cy="1505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18)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D8379CCD-0979-7247-BBEF-5DA5F6DE510F}"/>
              </a:ext>
            </a:extLst>
          </p:cNvPr>
          <p:cNvSpPr txBox="1"/>
          <p:nvPr/>
        </p:nvSpPr>
        <p:spPr>
          <a:xfrm>
            <a:off x="3597940" y="3840359"/>
            <a:ext cx="355097" cy="1505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31)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id="{F954A656-7F39-5A4A-8EEC-39F8B71B1D82}"/>
              </a:ext>
            </a:extLst>
          </p:cNvPr>
          <p:cNvCxnSpPr>
            <a:cxnSpLocks/>
          </p:cNvCxnSpPr>
          <p:nvPr/>
        </p:nvCxnSpPr>
        <p:spPr>
          <a:xfrm>
            <a:off x="3510131" y="5499235"/>
            <a:ext cx="76055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直線コネクタ 177">
            <a:extLst>
              <a:ext uri="{FF2B5EF4-FFF2-40B4-BE49-F238E27FC236}">
                <a16:creationId xmlns:a16="http://schemas.microsoft.com/office/drawing/2014/main" id="{5D532655-538E-874A-AC98-952792C5DD67}"/>
              </a:ext>
            </a:extLst>
          </p:cNvPr>
          <p:cNvCxnSpPr>
            <a:cxnSpLocks/>
          </p:cNvCxnSpPr>
          <p:nvPr/>
        </p:nvCxnSpPr>
        <p:spPr>
          <a:xfrm>
            <a:off x="3515787" y="5449436"/>
            <a:ext cx="0" cy="520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直線コネクタ 178">
            <a:extLst>
              <a:ext uri="{FF2B5EF4-FFF2-40B4-BE49-F238E27FC236}">
                <a16:creationId xmlns:a16="http://schemas.microsoft.com/office/drawing/2014/main" id="{848C1004-27FC-914D-8885-B9A09948B081}"/>
              </a:ext>
            </a:extLst>
          </p:cNvPr>
          <p:cNvCxnSpPr>
            <a:cxnSpLocks/>
          </p:cNvCxnSpPr>
          <p:nvPr/>
        </p:nvCxnSpPr>
        <p:spPr>
          <a:xfrm>
            <a:off x="4266015" y="5451733"/>
            <a:ext cx="0" cy="5209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直線コネクタ 179">
            <a:extLst>
              <a:ext uri="{FF2B5EF4-FFF2-40B4-BE49-F238E27FC236}">
                <a16:creationId xmlns:a16="http://schemas.microsoft.com/office/drawing/2014/main" id="{3573E070-11FC-7A45-A744-95BC823D7763}"/>
              </a:ext>
            </a:extLst>
          </p:cNvPr>
          <p:cNvCxnSpPr>
            <a:cxnSpLocks/>
          </p:cNvCxnSpPr>
          <p:nvPr/>
        </p:nvCxnSpPr>
        <p:spPr>
          <a:xfrm>
            <a:off x="1395859" y="5535890"/>
            <a:ext cx="7389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直線コネクタ 180">
            <a:extLst>
              <a:ext uri="{FF2B5EF4-FFF2-40B4-BE49-F238E27FC236}">
                <a16:creationId xmlns:a16="http://schemas.microsoft.com/office/drawing/2014/main" id="{108A1A73-8448-3B4A-8224-660F5D91E2A1}"/>
              </a:ext>
            </a:extLst>
          </p:cNvPr>
          <p:cNvCxnSpPr>
            <a:cxnSpLocks/>
          </p:cNvCxnSpPr>
          <p:nvPr/>
        </p:nvCxnSpPr>
        <p:spPr>
          <a:xfrm>
            <a:off x="1401354" y="5479278"/>
            <a:ext cx="0" cy="592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直線コネクタ 181">
            <a:extLst>
              <a:ext uri="{FF2B5EF4-FFF2-40B4-BE49-F238E27FC236}">
                <a16:creationId xmlns:a16="http://schemas.microsoft.com/office/drawing/2014/main" id="{A0F4FA3C-E8DF-4944-85E4-5B6256332B0E}"/>
              </a:ext>
            </a:extLst>
          </p:cNvPr>
          <p:cNvCxnSpPr>
            <a:cxnSpLocks/>
          </p:cNvCxnSpPr>
          <p:nvPr/>
        </p:nvCxnSpPr>
        <p:spPr>
          <a:xfrm>
            <a:off x="2130269" y="5481890"/>
            <a:ext cx="0" cy="592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正方形/長方形 182">
            <a:extLst>
              <a:ext uri="{FF2B5EF4-FFF2-40B4-BE49-F238E27FC236}">
                <a16:creationId xmlns:a16="http://schemas.microsoft.com/office/drawing/2014/main" id="{580B3A94-F60E-134E-958E-0CF7679797A4}"/>
              </a:ext>
            </a:extLst>
          </p:cNvPr>
          <p:cNvSpPr/>
          <p:nvPr/>
        </p:nvSpPr>
        <p:spPr>
          <a:xfrm>
            <a:off x="434335" y="3295869"/>
            <a:ext cx="2439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正方形/長方形 183">
            <a:extLst>
              <a:ext uri="{FF2B5EF4-FFF2-40B4-BE49-F238E27FC236}">
                <a16:creationId xmlns:a16="http://schemas.microsoft.com/office/drawing/2014/main" id="{3F2BFF3C-8D6D-744C-B1CF-5910A09968C2}"/>
              </a:ext>
            </a:extLst>
          </p:cNvPr>
          <p:cNvSpPr/>
          <p:nvPr/>
        </p:nvSpPr>
        <p:spPr>
          <a:xfrm>
            <a:off x="3571255" y="5505945"/>
            <a:ext cx="381782" cy="15052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i="1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&lt;0.001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正方形/長方形 184">
            <a:extLst>
              <a:ext uri="{FF2B5EF4-FFF2-40B4-BE49-F238E27FC236}">
                <a16:creationId xmlns:a16="http://schemas.microsoft.com/office/drawing/2014/main" id="{A5E1BB19-5DF6-5E43-AC65-65E16ECE57B8}"/>
              </a:ext>
            </a:extLst>
          </p:cNvPr>
          <p:cNvSpPr/>
          <p:nvPr/>
        </p:nvSpPr>
        <p:spPr>
          <a:xfrm>
            <a:off x="1458918" y="5523145"/>
            <a:ext cx="381782" cy="15052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i="1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=0.003</a:t>
            </a:r>
            <a:r>
              <a:rPr lang="ja-JP" altLang="ja-JP" sz="11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正方形/長方形 185">
            <a:extLst>
              <a:ext uri="{FF2B5EF4-FFF2-40B4-BE49-F238E27FC236}">
                <a16:creationId xmlns:a16="http://schemas.microsoft.com/office/drawing/2014/main" id="{F73001F5-C551-6641-8AC8-08C70A4F9EC3}"/>
              </a:ext>
            </a:extLst>
          </p:cNvPr>
          <p:cNvSpPr/>
          <p:nvPr/>
        </p:nvSpPr>
        <p:spPr>
          <a:xfrm>
            <a:off x="5527399" y="3617418"/>
            <a:ext cx="6096000" cy="199817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ange of knowledge level from baseline</a:t>
            </a:r>
            <a:endParaRPr lang="ja-JP" altLang="ja-JP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, comparison between baseline and 1-month;H, comparison between baseline and 6-month;I, comparison between baseline and 12-month. 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an scores +/- SE of Knowledge tests are shown. The test for school children contained 6 questions </a:t>
            </a:r>
            <a:r>
              <a:rPr lang="en-US" altLang="ja-JP" sz="1200" spc="-3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ile that for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olescents and young adults was composed of 11 questions. The tests </a:t>
            </a:r>
            <a:r>
              <a:rPr lang="en-US" altLang="ja-JP" sz="1200" spc="-3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quired yes-or-no answers. The total score of right answers were 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ed between the baseline assessment and each of post-intervention assessments with the paired student </a:t>
            </a:r>
            <a:r>
              <a:rPr lang="en-US" altLang="ja-JP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test. </a:t>
            </a:r>
            <a:endParaRPr lang="ja-JP" altLang="ja-JP" sz="120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7" name="グラフ 186">
            <a:extLst>
              <a:ext uri="{FF2B5EF4-FFF2-40B4-BE49-F238E27FC236}">
                <a16:creationId xmlns:a16="http://schemas.microsoft.com/office/drawing/2014/main" id="{E17F4B55-8305-3649-A546-D16F5FCB4C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2150625"/>
              </p:ext>
            </p:extLst>
          </p:nvPr>
        </p:nvGraphicFramePr>
        <p:xfrm>
          <a:off x="2758649" y="4137575"/>
          <a:ext cx="1977846" cy="17792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88" name="グラフ 187">
            <a:extLst>
              <a:ext uri="{FF2B5EF4-FFF2-40B4-BE49-F238E27FC236}">
                <a16:creationId xmlns:a16="http://schemas.microsoft.com/office/drawing/2014/main" id="{C7C72BCD-5E8E-6C47-8AAE-8D9EA606416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7838392"/>
              </p:ext>
            </p:extLst>
          </p:nvPr>
        </p:nvGraphicFramePr>
        <p:xfrm>
          <a:off x="2716514" y="1042543"/>
          <a:ext cx="2179132" cy="17594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77A7E7A7-C192-804E-84CF-0F1247871950}"/>
              </a:ext>
            </a:extLst>
          </p:cNvPr>
          <p:cNvSpPr/>
          <p:nvPr/>
        </p:nvSpPr>
        <p:spPr>
          <a:xfrm>
            <a:off x="434335" y="162559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A6E2A3D0-308E-7841-90E1-E7C107372E3F}"/>
              </a:ext>
            </a:extLst>
          </p:cNvPr>
          <p:cNvSpPr/>
          <p:nvPr/>
        </p:nvSpPr>
        <p:spPr>
          <a:xfrm>
            <a:off x="5941076" y="172978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6522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568</Words>
  <Application>Microsoft Macintosh PowerPoint</Application>
  <PresentationFormat>ワイド画面</PresentationFormat>
  <Paragraphs>9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ＭＳ Ｐゴシック</vt:lpstr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12</cp:revision>
  <dcterms:created xsi:type="dcterms:W3CDTF">2021-01-20T08:03:47Z</dcterms:created>
  <dcterms:modified xsi:type="dcterms:W3CDTF">2022-02-10T12:34:06Z</dcterms:modified>
</cp:coreProperties>
</file>